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_rels/data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image" Target="../media/image1.jpg"/><Relationship Id="rId4" Type="http://schemas.openxmlformats.org/officeDocument/2006/relationships/image" Target="../media/image4.jpg"/></Relationships>
</file>

<file path=ppt/diagram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image" Target="../media/image1.jpg"/><Relationship Id="rId4" Type="http://schemas.openxmlformats.org/officeDocument/2006/relationships/image" Target="../media/image4.jp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8B9B85F-844F-4311-BB51-E10947349E0F}" type="doc">
      <dgm:prSet loTypeId="urn:microsoft.com/office/officeart/2005/8/layout/pList2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6ECFCC84-17CD-4A09-8702-013585A29B85}">
      <dgm:prSet phldrT="[Text]" custT="1"/>
      <dgm:spPr/>
      <dgm:t>
        <a:bodyPr/>
        <a:lstStyle/>
        <a:p>
          <a:endParaRPr lang="en-US" sz="1600" dirty="0"/>
        </a:p>
      </dgm:t>
    </dgm:pt>
    <dgm:pt modelId="{F0B8FC48-046E-4F13-BB24-0A64605A5CED}" type="parTrans" cxnId="{357EF9F2-0727-458E-8268-2A75A6106B36}">
      <dgm:prSet/>
      <dgm:spPr/>
      <dgm:t>
        <a:bodyPr/>
        <a:lstStyle/>
        <a:p>
          <a:endParaRPr lang="en-US"/>
        </a:p>
      </dgm:t>
    </dgm:pt>
    <dgm:pt modelId="{1219738F-3160-4F0F-A271-0873CB2F268C}" type="sibTrans" cxnId="{357EF9F2-0727-458E-8268-2A75A6106B36}">
      <dgm:prSet/>
      <dgm:spPr/>
      <dgm:t>
        <a:bodyPr/>
        <a:lstStyle/>
        <a:p>
          <a:endParaRPr lang="en-US"/>
        </a:p>
      </dgm:t>
    </dgm:pt>
    <dgm:pt modelId="{7B9AAB67-DDD3-4639-860B-619A7ADAEA16}">
      <dgm:prSet phldrT="[Text]" custT="1"/>
      <dgm:spPr/>
      <dgm:t>
        <a:bodyPr/>
        <a:lstStyle/>
        <a:p>
          <a:endParaRPr lang="en-US" sz="1800" dirty="0"/>
        </a:p>
      </dgm:t>
    </dgm:pt>
    <dgm:pt modelId="{9426FE76-1CB5-4D0A-BBF4-49CA62519CA8}" type="parTrans" cxnId="{3D656D23-BBEA-4AAA-ABE4-9A7FC2C28264}">
      <dgm:prSet/>
      <dgm:spPr/>
      <dgm:t>
        <a:bodyPr/>
        <a:lstStyle/>
        <a:p>
          <a:endParaRPr lang="en-US"/>
        </a:p>
      </dgm:t>
    </dgm:pt>
    <dgm:pt modelId="{D581F235-2DDD-4C3B-A044-C95666420CEE}" type="sibTrans" cxnId="{3D656D23-BBEA-4AAA-ABE4-9A7FC2C28264}">
      <dgm:prSet/>
      <dgm:spPr/>
      <dgm:t>
        <a:bodyPr/>
        <a:lstStyle/>
        <a:p>
          <a:endParaRPr lang="en-US"/>
        </a:p>
      </dgm:t>
    </dgm:pt>
    <dgm:pt modelId="{059E22DC-E5C0-49B9-B78D-1ED4F121E156}">
      <dgm:prSet phldrT="[Text]"/>
      <dgm:spPr/>
      <dgm:t>
        <a:bodyPr/>
        <a:lstStyle/>
        <a:p>
          <a:endParaRPr lang="en-US" sz="2600" dirty="0"/>
        </a:p>
      </dgm:t>
    </dgm:pt>
    <dgm:pt modelId="{67B16BBF-B796-441E-872F-05557CB413C9}" type="parTrans" cxnId="{FCB2E3D9-039A-4C3A-8903-7CB10EDCDE39}">
      <dgm:prSet/>
      <dgm:spPr/>
      <dgm:t>
        <a:bodyPr/>
        <a:lstStyle/>
        <a:p>
          <a:endParaRPr lang="en-US"/>
        </a:p>
      </dgm:t>
    </dgm:pt>
    <dgm:pt modelId="{650AACE4-143E-4531-B742-DE38B20A2C40}" type="sibTrans" cxnId="{FCB2E3D9-039A-4C3A-8903-7CB10EDCDE39}">
      <dgm:prSet/>
      <dgm:spPr/>
      <dgm:t>
        <a:bodyPr/>
        <a:lstStyle/>
        <a:p>
          <a:endParaRPr lang="en-US"/>
        </a:p>
      </dgm:t>
    </dgm:pt>
    <dgm:pt modelId="{77538CCD-257C-4F6D-8885-50C64322C82F}">
      <dgm:prSet/>
      <dgm:spPr/>
      <dgm:t>
        <a:bodyPr/>
        <a:lstStyle/>
        <a:p>
          <a:endParaRPr lang="en-US" sz="2600" dirty="0"/>
        </a:p>
      </dgm:t>
    </dgm:pt>
    <dgm:pt modelId="{B2601949-CF72-4FD5-9444-DB7AB9441CCB}" type="parTrans" cxnId="{61DAA5D1-C008-4B0A-B5AD-DDE9F50D4C6C}">
      <dgm:prSet/>
      <dgm:spPr/>
      <dgm:t>
        <a:bodyPr/>
        <a:lstStyle/>
        <a:p>
          <a:endParaRPr lang="en-US"/>
        </a:p>
      </dgm:t>
    </dgm:pt>
    <dgm:pt modelId="{7444D001-CADE-40CC-B46C-C33E1876C50A}" type="sibTrans" cxnId="{61DAA5D1-C008-4B0A-B5AD-DDE9F50D4C6C}">
      <dgm:prSet/>
      <dgm:spPr/>
      <dgm:t>
        <a:bodyPr/>
        <a:lstStyle/>
        <a:p>
          <a:endParaRPr lang="en-US"/>
        </a:p>
      </dgm:t>
    </dgm:pt>
    <dgm:pt modelId="{0551C229-4671-4B10-A40D-92F7E52EE9ED}">
      <dgm:prSet custT="1"/>
      <dgm:spPr/>
      <dgm:t>
        <a:bodyPr/>
        <a:lstStyle/>
        <a:p>
          <a:r>
            <a:rPr lang="en-US" sz="1200" dirty="0"/>
            <a:t>No changes in weight and BMI</a:t>
          </a:r>
        </a:p>
      </dgm:t>
    </dgm:pt>
    <dgm:pt modelId="{A5E84AC7-23AD-4673-BFD3-305AC45CE678}" type="parTrans" cxnId="{61A284A1-C86D-4BA7-9428-5B05431C4CC3}">
      <dgm:prSet/>
      <dgm:spPr/>
      <dgm:t>
        <a:bodyPr/>
        <a:lstStyle/>
        <a:p>
          <a:endParaRPr lang="en-US"/>
        </a:p>
      </dgm:t>
    </dgm:pt>
    <dgm:pt modelId="{65FD06B1-DD58-4255-92A3-D225A0CDC9CB}" type="sibTrans" cxnId="{61A284A1-C86D-4BA7-9428-5B05431C4CC3}">
      <dgm:prSet/>
      <dgm:spPr/>
      <dgm:t>
        <a:bodyPr/>
        <a:lstStyle/>
        <a:p>
          <a:endParaRPr lang="en-US"/>
        </a:p>
      </dgm:t>
    </dgm:pt>
    <dgm:pt modelId="{31BA1495-1F57-4A84-80CD-D39B0590163B}">
      <dgm:prSet custT="1"/>
      <dgm:spPr/>
      <dgm:t>
        <a:bodyPr/>
        <a:lstStyle/>
        <a:p>
          <a:endParaRPr lang="en-US" sz="1400" dirty="0"/>
        </a:p>
      </dgm:t>
    </dgm:pt>
    <dgm:pt modelId="{C69104B2-1949-4226-941E-D539A333956C}" type="parTrans" cxnId="{0C97071E-D9A7-49F8-B73B-BC558B56556F}">
      <dgm:prSet/>
      <dgm:spPr/>
      <dgm:t>
        <a:bodyPr/>
        <a:lstStyle/>
        <a:p>
          <a:endParaRPr lang="en-US"/>
        </a:p>
      </dgm:t>
    </dgm:pt>
    <dgm:pt modelId="{DD5DE76C-96DE-4C8B-8870-F339498E9F8E}" type="sibTrans" cxnId="{0C97071E-D9A7-49F8-B73B-BC558B56556F}">
      <dgm:prSet/>
      <dgm:spPr/>
      <dgm:t>
        <a:bodyPr/>
        <a:lstStyle/>
        <a:p>
          <a:endParaRPr lang="en-US"/>
        </a:p>
      </dgm:t>
    </dgm:pt>
    <dgm:pt modelId="{A3F4D300-8B3F-4E0A-A359-122E7D86F4B4}">
      <dgm:prSet custT="1"/>
      <dgm:spPr/>
      <dgm:t>
        <a:bodyPr/>
        <a:lstStyle/>
        <a:p>
          <a:r>
            <a:rPr lang="en-US" sz="1200" dirty="0"/>
            <a:t>Reduction in weight and BMI</a:t>
          </a:r>
        </a:p>
      </dgm:t>
    </dgm:pt>
    <dgm:pt modelId="{984951E1-CD2D-4AA0-99F2-FA66EC0B7C4D}" type="parTrans" cxnId="{E0A08A16-2F70-411C-A4B7-0C9643BB36EC}">
      <dgm:prSet/>
      <dgm:spPr/>
      <dgm:t>
        <a:bodyPr/>
        <a:lstStyle/>
        <a:p>
          <a:endParaRPr lang="en-US"/>
        </a:p>
      </dgm:t>
    </dgm:pt>
    <dgm:pt modelId="{09326B66-C578-480B-831B-29E92A32F533}" type="sibTrans" cxnId="{E0A08A16-2F70-411C-A4B7-0C9643BB36EC}">
      <dgm:prSet/>
      <dgm:spPr/>
      <dgm:t>
        <a:bodyPr/>
        <a:lstStyle/>
        <a:p>
          <a:endParaRPr lang="en-US"/>
        </a:p>
      </dgm:t>
    </dgm:pt>
    <dgm:pt modelId="{F8594DF8-C229-4BE1-BD62-9EE1CE68AFBF}">
      <dgm:prSet custT="1"/>
      <dgm:spPr/>
      <dgm:t>
        <a:bodyPr/>
        <a:lstStyle/>
        <a:p>
          <a:r>
            <a:rPr lang="en-US" sz="1200" dirty="0"/>
            <a:t>Reduction in weight and BMI</a:t>
          </a:r>
        </a:p>
      </dgm:t>
    </dgm:pt>
    <dgm:pt modelId="{43F208CA-3A39-443C-885A-0D871C7D5B9C}" type="parTrans" cxnId="{C72B175F-33ED-4BB2-AB56-084520751707}">
      <dgm:prSet/>
      <dgm:spPr/>
      <dgm:t>
        <a:bodyPr/>
        <a:lstStyle/>
        <a:p>
          <a:endParaRPr lang="en-US"/>
        </a:p>
      </dgm:t>
    </dgm:pt>
    <dgm:pt modelId="{C90ACB1B-57A5-4221-B4C7-A7FFCB21EB4D}" type="sibTrans" cxnId="{C72B175F-33ED-4BB2-AB56-084520751707}">
      <dgm:prSet/>
      <dgm:spPr/>
      <dgm:t>
        <a:bodyPr/>
        <a:lstStyle/>
        <a:p>
          <a:endParaRPr lang="en-US"/>
        </a:p>
      </dgm:t>
    </dgm:pt>
    <dgm:pt modelId="{A9E892F1-BAA2-4DC0-AB0B-E151F3826843}">
      <dgm:prSet custT="1"/>
      <dgm:spPr/>
      <dgm:t>
        <a:bodyPr/>
        <a:lstStyle/>
        <a:p>
          <a:r>
            <a:rPr lang="en-US" sz="1200" dirty="0"/>
            <a:t>Reduction in weight and BMI</a:t>
          </a:r>
        </a:p>
      </dgm:t>
    </dgm:pt>
    <dgm:pt modelId="{7329DF87-68A4-47FD-A197-D450034B7141}" type="parTrans" cxnId="{7782AC63-DA4E-433B-ACB0-32CC7F59D9E5}">
      <dgm:prSet/>
      <dgm:spPr/>
      <dgm:t>
        <a:bodyPr/>
        <a:lstStyle/>
        <a:p>
          <a:endParaRPr lang="en-US"/>
        </a:p>
      </dgm:t>
    </dgm:pt>
    <dgm:pt modelId="{3129492F-843F-4E07-AEC9-2214A6F9F494}" type="sibTrans" cxnId="{7782AC63-DA4E-433B-ACB0-32CC7F59D9E5}">
      <dgm:prSet/>
      <dgm:spPr/>
      <dgm:t>
        <a:bodyPr/>
        <a:lstStyle/>
        <a:p>
          <a:endParaRPr lang="en-US"/>
        </a:p>
      </dgm:t>
    </dgm:pt>
    <dgm:pt modelId="{CB9A3220-9BA1-40CA-A27C-A05772717882}">
      <dgm:prSet custT="1"/>
      <dgm:spPr/>
      <dgm:t>
        <a:bodyPr/>
        <a:lstStyle/>
        <a:p>
          <a:endParaRPr lang="en-US" sz="1400" dirty="0"/>
        </a:p>
      </dgm:t>
    </dgm:pt>
    <dgm:pt modelId="{9F147C10-D824-4C6F-B656-C0238B952D95}" type="parTrans" cxnId="{306C4E4A-F379-4D11-9C3C-0094029FD2EA}">
      <dgm:prSet/>
      <dgm:spPr/>
      <dgm:t>
        <a:bodyPr/>
        <a:lstStyle/>
        <a:p>
          <a:endParaRPr lang="en-US"/>
        </a:p>
      </dgm:t>
    </dgm:pt>
    <dgm:pt modelId="{6DB0D7D1-B297-489F-849E-97192EE6D0C7}" type="sibTrans" cxnId="{306C4E4A-F379-4D11-9C3C-0094029FD2EA}">
      <dgm:prSet/>
      <dgm:spPr/>
      <dgm:t>
        <a:bodyPr/>
        <a:lstStyle/>
        <a:p>
          <a:endParaRPr lang="en-US"/>
        </a:p>
      </dgm:t>
    </dgm:pt>
    <dgm:pt modelId="{8873D990-7EC3-452C-AA3B-935913CCD64B}">
      <dgm:prSet custT="1"/>
      <dgm:spPr/>
      <dgm:t>
        <a:bodyPr/>
        <a:lstStyle/>
        <a:p>
          <a:r>
            <a:rPr lang="en-US" sz="1200" dirty="0"/>
            <a:t>Improvement in insulin resistance (HOMA-IR) </a:t>
          </a:r>
        </a:p>
      </dgm:t>
    </dgm:pt>
    <dgm:pt modelId="{6E7AB4E0-5EFE-481C-94EB-8E485F478F64}" type="parTrans" cxnId="{9A952679-4E4F-4609-9866-36B065BF5265}">
      <dgm:prSet/>
      <dgm:spPr/>
      <dgm:t>
        <a:bodyPr/>
        <a:lstStyle/>
        <a:p>
          <a:endParaRPr lang="en-US"/>
        </a:p>
      </dgm:t>
    </dgm:pt>
    <dgm:pt modelId="{1497520C-068E-47AB-8685-699E8DF86333}" type="sibTrans" cxnId="{9A952679-4E4F-4609-9866-36B065BF5265}">
      <dgm:prSet/>
      <dgm:spPr/>
      <dgm:t>
        <a:bodyPr/>
        <a:lstStyle/>
        <a:p>
          <a:endParaRPr lang="en-US"/>
        </a:p>
      </dgm:t>
    </dgm:pt>
    <dgm:pt modelId="{249A57EF-E067-43D5-8021-9A741118244D}">
      <dgm:prSet custT="1"/>
      <dgm:spPr/>
      <dgm:t>
        <a:bodyPr/>
        <a:lstStyle/>
        <a:p>
          <a:endParaRPr lang="en-US" sz="1400" dirty="0"/>
        </a:p>
      </dgm:t>
    </dgm:pt>
    <dgm:pt modelId="{FFF49758-E759-4940-BC82-1165FB5E2EBD}" type="parTrans" cxnId="{8BFDF891-41AD-4F16-87BB-E1C16350F288}">
      <dgm:prSet/>
      <dgm:spPr/>
      <dgm:t>
        <a:bodyPr/>
        <a:lstStyle/>
        <a:p>
          <a:endParaRPr lang="en-US"/>
        </a:p>
      </dgm:t>
    </dgm:pt>
    <dgm:pt modelId="{DE264E2C-C557-42FD-9D24-FDBCF8B7DC93}" type="sibTrans" cxnId="{8BFDF891-41AD-4F16-87BB-E1C16350F288}">
      <dgm:prSet/>
      <dgm:spPr/>
      <dgm:t>
        <a:bodyPr/>
        <a:lstStyle/>
        <a:p>
          <a:endParaRPr lang="en-US"/>
        </a:p>
      </dgm:t>
    </dgm:pt>
    <dgm:pt modelId="{96365B3E-A9F4-4C8E-A8C1-B7DCE6C0915C}">
      <dgm:prSet custT="1"/>
      <dgm:spPr/>
      <dgm:t>
        <a:bodyPr/>
        <a:lstStyle/>
        <a:p>
          <a:r>
            <a:rPr lang="en-US" sz="1200" dirty="0"/>
            <a:t>Improvement in insulin resistance (HOMA-IR) </a:t>
          </a:r>
        </a:p>
      </dgm:t>
    </dgm:pt>
    <dgm:pt modelId="{1BEBFD84-1988-4960-BDB0-26407CB69913}" type="parTrans" cxnId="{3D27880D-02B7-4B52-B834-DCBD940DE5ED}">
      <dgm:prSet/>
      <dgm:spPr/>
      <dgm:t>
        <a:bodyPr/>
        <a:lstStyle/>
        <a:p>
          <a:endParaRPr lang="en-US"/>
        </a:p>
      </dgm:t>
    </dgm:pt>
    <dgm:pt modelId="{3F707618-A1A8-4EF4-9B2C-53E2A1DAEAFB}" type="sibTrans" cxnId="{3D27880D-02B7-4B52-B834-DCBD940DE5ED}">
      <dgm:prSet/>
      <dgm:spPr/>
      <dgm:t>
        <a:bodyPr/>
        <a:lstStyle/>
        <a:p>
          <a:endParaRPr lang="en-US"/>
        </a:p>
      </dgm:t>
    </dgm:pt>
    <dgm:pt modelId="{698DBBC0-9979-41C9-996D-D211B1D30E0D}">
      <dgm:prSet custT="1"/>
      <dgm:spPr/>
      <dgm:t>
        <a:bodyPr/>
        <a:lstStyle/>
        <a:p>
          <a:r>
            <a:rPr lang="en-US" sz="1200" dirty="0"/>
            <a:t>No changes in insulin resistance </a:t>
          </a:r>
        </a:p>
      </dgm:t>
    </dgm:pt>
    <dgm:pt modelId="{43EEF37B-9669-4AE4-AD8E-B870BE4DAB7A}" type="parTrans" cxnId="{7DD99C89-2ABD-4957-B0A4-13F43F0712C1}">
      <dgm:prSet/>
      <dgm:spPr/>
      <dgm:t>
        <a:bodyPr/>
        <a:lstStyle/>
        <a:p>
          <a:endParaRPr lang="en-US"/>
        </a:p>
      </dgm:t>
    </dgm:pt>
    <dgm:pt modelId="{3154FB6C-A7FA-4D0B-A359-AA2BE43EE9A9}" type="sibTrans" cxnId="{7DD99C89-2ABD-4957-B0A4-13F43F0712C1}">
      <dgm:prSet/>
      <dgm:spPr/>
      <dgm:t>
        <a:bodyPr/>
        <a:lstStyle/>
        <a:p>
          <a:endParaRPr lang="en-US"/>
        </a:p>
      </dgm:t>
    </dgm:pt>
    <dgm:pt modelId="{FD85822D-7FC3-4D15-B0AD-B84E36EFDB27}">
      <dgm:prSet custT="1"/>
      <dgm:spPr/>
      <dgm:t>
        <a:bodyPr/>
        <a:lstStyle/>
        <a:p>
          <a:r>
            <a:rPr lang="en-US" sz="1200" dirty="0"/>
            <a:t>No changes in insulin resistance</a:t>
          </a:r>
        </a:p>
      </dgm:t>
    </dgm:pt>
    <dgm:pt modelId="{9B40B9F0-51E5-4DB3-BEE1-CA3C0A58BD7C}" type="parTrans" cxnId="{353459FE-C67A-43CF-B89D-2CD7E19E9C93}">
      <dgm:prSet/>
      <dgm:spPr/>
      <dgm:t>
        <a:bodyPr/>
        <a:lstStyle/>
        <a:p>
          <a:endParaRPr lang="en-US"/>
        </a:p>
      </dgm:t>
    </dgm:pt>
    <dgm:pt modelId="{687FBBE4-D94C-453C-AF69-60B8F0E31325}" type="sibTrans" cxnId="{353459FE-C67A-43CF-B89D-2CD7E19E9C93}">
      <dgm:prSet/>
      <dgm:spPr/>
      <dgm:t>
        <a:bodyPr/>
        <a:lstStyle/>
        <a:p>
          <a:endParaRPr lang="en-US"/>
        </a:p>
      </dgm:t>
    </dgm:pt>
    <dgm:pt modelId="{2996153D-AC5D-4677-9FB4-E6F3EE72E7CA}">
      <dgm:prSet custT="1"/>
      <dgm:spPr/>
      <dgm:t>
        <a:bodyPr/>
        <a:lstStyle/>
        <a:p>
          <a:endParaRPr lang="en-US" sz="1400" dirty="0"/>
        </a:p>
      </dgm:t>
    </dgm:pt>
    <dgm:pt modelId="{B37B98D0-8548-4F32-85D0-F8D8E0E06386}" type="parTrans" cxnId="{F2181C1B-D854-4636-8665-41EE5B05415F}">
      <dgm:prSet/>
      <dgm:spPr/>
      <dgm:t>
        <a:bodyPr/>
        <a:lstStyle/>
        <a:p>
          <a:endParaRPr lang="en-US"/>
        </a:p>
      </dgm:t>
    </dgm:pt>
    <dgm:pt modelId="{7736A0D5-FB09-4BC2-8FB0-F80F6F6F204A}" type="sibTrans" cxnId="{F2181C1B-D854-4636-8665-41EE5B05415F}">
      <dgm:prSet/>
      <dgm:spPr/>
      <dgm:t>
        <a:bodyPr/>
        <a:lstStyle/>
        <a:p>
          <a:endParaRPr lang="en-US"/>
        </a:p>
      </dgm:t>
    </dgm:pt>
    <dgm:pt modelId="{C07AF31F-C3D3-410C-A0EB-BC7137A710BD}">
      <dgm:prSet custT="1"/>
      <dgm:spPr/>
      <dgm:t>
        <a:bodyPr/>
        <a:lstStyle/>
        <a:p>
          <a:r>
            <a:rPr lang="en-US" sz="1200" dirty="0"/>
            <a:t>Decrease FSH and LH levels</a:t>
          </a:r>
        </a:p>
      </dgm:t>
    </dgm:pt>
    <dgm:pt modelId="{3201EBEB-2821-4CB0-AD45-F2B7736CAFB2}" type="parTrans" cxnId="{1E0A0B7F-6BD5-461E-A445-FCC3503551BD}">
      <dgm:prSet/>
      <dgm:spPr/>
      <dgm:t>
        <a:bodyPr/>
        <a:lstStyle/>
        <a:p>
          <a:endParaRPr lang="en-US"/>
        </a:p>
      </dgm:t>
    </dgm:pt>
    <dgm:pt modelId="{4E786301-B378-46A4-9F02-AC2F410ECB1F}" type="sibTrans" cxnId="{1E0A0B7F-6BD5-461E-A445-FCC3503551BD}">
      <dgm:prSet/>
      <dgm:spPr/>
      <dgm:t>
        <a:bodyPr/>
        <a:lstStyle/>
        <a:p>
          <a:endParaRPr lang="en-US"/>
        </a:p>
      </dgm:t>
    </dgm:pt>
    <dgm:pt modelId="{ABF06B23-0317-49B6-9A1A-F48B33C976A8}">
      <dgm:prSet custT="1"/>
      <dgm:spPr/>
      <dgm:t>
        <a:bodyPr/>
        <a:lstStyle/>
        <a:p>
          <a:r>
            <a:rPr lang="en-US" sz="1200" dirty="0"/>
            <a:t>No significant changes in FSH and LH</a:t>
          </a:r>
        </a:p>
      </dgm:t>
    </dgm:pt>
    <dgm:pt modelId="{B41B659F-1784-4409-BF7A-1D47ADD32837}" type="parTrans" cxnId="{8E1BF899-9C65-44D6-A6EB-11C73E2756A6}">
      <dgm:prSet/>
      <dgm:spPr/>
      <dgm:t>
        <a:bodyPr/>
        <a:lstStyle/>
        <a:p>
          <a:endParaRPr lang="en-US"/>
        </a:p>
      </dgm:t>
    </dgm:pt>
    <dgm:pt modelId="{88B80D8F-FB59-4CA8-8420-E9CC93E44910}" type="sibTrans" cxnId="{8E1BF899-9C65-44D6-A6EB-11C73E2756A6}">
      <dgm:prSet/>
      <dgm:spPr/>
      <dgm:t>
        <a:bodyPr/>
        <a:lstStyle/>
        <a:p>
          <a:endParaRPr lang="en-US"/>
        </a:p>
      </dgm:t>
    </dgm:pt>
    <dgm:pt modelId="{6D4A96F1-F584-46DC-B270-FD6F2A173748}">
      <dgm:prSet custT="1"/>
      <dgm:spPr/>
      <dgm:t>
        <a:bodyPr/>
        <a:lstStyle/>
        <a:p>
          <a:r>
            <a:rPr lang="en-US" sz="1200" dirty="0"/>
            <a:t>lowered testosterone levels </a:t>
          </a:r>
        </a:p>
      </dgm:t>
    </dgm:pt>
    <dgm:pt modelId="{386E638A-517A-427E-A4AC-9E0F3EF40DC4}" type="parTrans" cxnId="{220CFB7B-F0C7-42A7-B030-B4B1AEC06E21}">
      <dgm:prSet/>
      <dgm:spPr/>
      <dgm:t>
        <a:bodyPr/>
        <a:lstStyle/>
        <a:p>
          <a:endParaRPr lang="en-US"/>
        </a:p>
      </dgm:t>
    </dgm:pt>
    <dgm:pt modelId="{D30BCA6F-B04E-439C-A600-A78F990AE634}" type="sibTrans" cxnId="{220CFB7B-F0C7-42A7-B030-B4B1AEC06E21}">
      <dgm:prSet/>
      <dgm:spPr/>
      <dgm:t>
        <a:bodyPr/>
        <a:lstStyle/>
        <a:p>
          <a:endParaRPr lang="en-US"/>
        </a:p>
      </dgm:t>
    </dgm:pt>
    <dgm:pt modelId="{A1669F18-1E4A-47F1-ACEB-A4AA8F0ABC19}">
      <dgm:prSet custT="1"/>
      <dgm:spPr/>
      <dgm:t>
        <a:bodyPr/>
        <a:lstStyle/>
        <a:p>
          <a:endParaRPr lang="en-US" sz="1400" dirty="0"/>
        </a:p>
      </dgm:t>
    </dgm:pt>
    <dgm:pt modelId="{C4FBBD02-0E12-406A-AD98-2A02F400C4F0}" type="parTrans" cxnId="{CCC2DACB-D79A-40A9-B05D-2090A4498F3D}">
      <dgm:prSet/>
      <dgm:spPr/>
      <dgm:t>
        <a:bodyPr/>
        <a:lstStyle/>
        <a:p>
          <a:endParaRPr lang="en-US"/>
        </a:p>
      </dgm:t>
    </dgm:pt>
    <dgm:pt modelId="{BC831E95-FBAB-4CA4-87E5-92D58E991656}" type="sibTrans" cxnId="{CCC2DACB-D79A-40A9-B05D-2090A4498F3D}">
      <dgm:prSet/>
      <dgm:spPr/>
      <dgm:t>
        <a:bodyPr/>
        <a:lstStyle/>
        <a:p>
          <a:endParaRPr lang="en-US"/>
        </a:p>
      </dgm:t>
    </dgm:pt>
    <dgm:pt modelId="{E16B6CD2-DF67-4D37-B15E-B6BBAD16AB23}">
      <dgm:prSet custT="1"/>
      <dgm:spPr/>
      <dgm:t>
        <a:bodyPr/>
        <a:lstStyle/>
        <a:p>
          <a:r>
            <a:rPr lang="en-US" sz="1200" dirty="0"/>
            <a:t>No significant changes in testosterone levels </a:t>
          </a:r>
        </a:p>
      </dgm:t>
    </dgm:pt>
    <dgm:pt modelId="{12F94176-07E0-4646-AE56-607DB14FC676}" type="parTrans" cxnId="{8D726B4D-3EBA-46B9-BEBA-24FF5EF4A3FE}">
      <dgm:prSet/>
      <dgm:spPr/>
      <dgm:t>
        <a:bodyPr/>
        <a:lstStyle/>
        <a:p>
          <a:endParaRPr lang="en-US"/>
        </a:p>
      </dgm:t>
    </dgm:pt>
    <dgm:pt modelId="{E87B321C-2B96-4DB5-9339-CF6C7F39D333}" type="sibTrans" cxnId="{8D726B4D-3EBA-46B9-BEBA-24FF5EF4A3FE}">
      <dgm:prSet/>
      <dgm:spPr/>
      <dgm:t>
        <a:bodyPr/>
        <a:lstStyle/>
        <a:p>
          <a:endParaRPr lang="en-US"/>
        </a:p>
      </dgm:t>
    </dgm:pt>
    <dgm:pt modelId="{65211C4B-89D9-4ABF-88B2-A4DB4F210F21}">
      <dgm:prSet custT="1"/>
      <dgm:spPr/>
      <dgm:t>
        <a:bodyPr/>
        <a:lstStyle/>
        <a:p>
          <a:endParaRPr lang="en-US" sz="1400" dirty="0"/>
        </a:p>
      </dgm:t>
    </dgm:pt>
    <dgm:pt modelId="{D598EFE6-B830-4B96-981E-F4788F8DCD87}" type="parTrans" cxnId="{1CACE472-BAAF-4C23-AE47-671998A4D1B0}">
      <dgm:prSet/>
      <dgm:spPr/>
      <dgm:t>
        <a:bodyPr/>
        <a:lstStyle/>
        <a:p>
          <a:endParaRPr lang="en-US"/>
        </a:p>
      </dgm:t>
    </dgm:pt>
    <dgm:pt modelId="{494788BD-0936-4BB4-B91B-1FE34CF94B05}" type="sibTrans" cxnId="{1CACE472-BAAF-4C23-AE47-671998A4D1B0}">
      <dgm:prSet/>
      <dgm:spPr/>
      <dgm:t>
        <a:bodyPr/>
        <a:lstStyle/>
        <a:p>
          <a:endParaRPr lang="en-US"/>
        </a:p>
      </dgm:t>
    </dgm:pt>
    <dgm:pt modelId="{D1986E71-B33B-4FAC-BB57-4B5CAFFB3491}">
      <dgm:prSet custT="1"/>
      <dgm:spPr/>
      <dgm:t>
        <a:bodyPr/>
        <a:lstStyle/>
        <a:p>
          <a:r>
            <a:rPr lang="en-US" sz="1200" dirty="0"/>
            <a:t>No significant changes in FSH and LH level</a:t>
          </a:r>
        </a:p>
      </dgm:t>
    </dgm:pt>
    <dgm:pt modelId="{468EEE1C-14D9-4929-B985-E47874BBC43A}" type="parTrans" cxnId="{7BD8EBA9-162D-4743-92E2-1ECD427AB285}">
      <dgm:prSet/>
      <dgm:spPr/>
      <dgm:t>
        <a:bodyPr/>
        <a:lstStyle/>
        <a:p>
          <a:endParaRPr lang="en-US"/>
        </a:p>
      </dgm:t>
    </dgm:pt>
    <dgm:pt modelId="{2A6F93F6-63E7-48E2-8A8A-389D939B2315}" type="sibTrans" cxnId="{7BD8EBA9-162D-4743-92E2-1ECD427AB285}">
      <dgm:prSet/>
      <dgm:spPr/>
      <dgm:t>
        <a:bodyPr/>
        <a:lstStyle/>
        <a:p>
          <a:endParaRPr lang="en-US"/>
        </a:p>
      </dgm:t>
    </dgm:pt>
    <dgm:pt modelId="{C714CE48-D6BE-47C8-867D-281FF0A35D62}">
      <dgm:prSet custT="1"/>
      <dgm:spPr/>
      <dgm:t>
        <a:bodyPr/>
        <a:lstStyle/>
        <a:p>
          <a:endParaRPr lang="en-US" sz="1400" dirty="0"/>
        </a:p>
      </dgm:t>
    </dgm:pt>
    <dgm:pt modelId="{885AEC9E-3561-495E-8596-6E90281B9C6F}" type="parTrans" cxnId="{8BFAF402-F69E-4D8E-8453-AD3C6E8C51E7}">
      <dgm:prSet/>
      <dgm:spPr/>
      <dgm:t>
        <a:bodyPr/>
        <a:lstStyle/>
        <a:p>
          <a:endParaRPr lang="en-US"/>
        </a:p>
      </dgm:t>
    </dgm:pt>
    <dgm:pt modelId="{27A7CEA4-90AF-4310-BA2C-9169178308A4}" type="sibTrans" cxnId="{8BFAF402-F69E-4D8E-8453-AD3C6E8C51E7}">
      <dgm:prSet/>
      <dgm:spPr/>
      <dgm:t>
        <a:bodyPr/>
        <a:lstStyle/>
        <a:p>
          <a:endParaRPr lang="en-US"/>
        </a:p>
      </dgm:t>
    </dgm:pt>
    <dgm:pt modelId="{EA9EFB14-F694-4DA2-BB92-7FA2FE079CF5}">
      <dgm:prSet custT="1"/>
      <dgm:spPr/>
      <dgm:t>
        <a:bodyPr/>
        <a:lstStyle/>
        <a:p>
          <a:endParaRPr lang="en-US" sz="1400" dirty="0"/>
        </a:p>
      </dgm:t>
    </dgm:pt>
    <dgm:pt modelId="{49899EEC-83D0-42C5-A4E4-8070FFAE8159}" type="parTrans" cxnId="{1B72B767-EC6A-4D5F-8C98-C2D11752F076}">
      <dgm:prSet/>
      <dgm:spPr/>
      <dgm:t>
        <a:bodyPr/>
        <a:lstStyle/>
        <a:p>
          <a:endParaRPr lang="en-US"/>
        </a:p>
      </dgm:t>
    </dgm:pt>
    <dgm:pt modelId="{CF3E91CB-51A1-48C9-BAF0-329F712C2C32}" type="sibTrans" cxnId="{1B72B767-EC6A-4D5F-8C98-C2D11752F076}">
      <dgm:prSet/>
      <dgm:spPr/>
      <dgm:t>
        <a:bodyPr/>
        <a:lstStyle/>
        <a:p>
          <a:endParaRPr lang="en-US"/>
        </a:p>
      </dgm:t>
    </dgm:pt>
    <dgm:pt modelId="{91B0690A-F0FE-41AD-8B2B-8CEB458BD515}">
      <dgm:prSet custT="1"/>
      <dgm:spPr/>
      <dgm:t>
        <a:bodyPr/>
        <a:lstStyle/>
        <a:p>
          <a:r>
            <a:rPr lang="en-US" sz="1200" dirty="0"/>
            <a:t>lowered testosterone levels</a:t>
          </a:r>
          <a:r>
            <a:rPr lang="en-US" sz="1400" dirty="0"/>
            <a:t> </a:t>
          </a:r>
        </a:p>
      </dgm:t>
    </dgm:pt>
    <dgm:pt modelId="{8686FB7B-A1B7-4BE4-A380-A4FE28BAA634}" type="parTrans" cxnId="{1CF86128-66BB-414A-BCFE-AC5B97C96716}">
      <dgm:prSet/>
      <dgm:spPr/>
      <dgm:t>
        <a:bodyPr/>
        <a:lstStyle/>
        <a:p>
          <a:endParaRPr lang="en-US"/>
        </a:p>
      </dgm:t>
    </dgm:pt>
    <dgm:pt modelId="{16A31D07-FB99-4344-A345-8A8299EB5AEA}" type="sibTrans" cxnId="{1CF86128-66BB-414A-BCFE-AC5B97C96716}">
      <dgm:prSet/>
      <dgm:spPr/>
      <dgm:t>
        <a:bodyPr/>
        <a:lstStyle/>
        <a:p>
          <a:endParaRPr lang="en-US"/>
        </a:p>
      </dgm:t>
    </dgm:pt>
    <dgm:pt modelId="{2BD618A9-AC49-4E19-83B7-51676688B442}">
      <dgm:prSet custT="1"/>
      <dgm:spPr/>
      <dgm:t>
        <a:bodyPr/>
        <a:lstStyle/>
        <a:p>
          <a:endParaRPr lang="en-US" sz="1200" dirty="0"/>
        </a:p>
      </dgm:t>
    </dgm:pt>
    <dgm:pt modelId="{4BB0327C-7263-466D-8D7F-4D1DB2A32C30}" type="parTrans" cxnId="{4F0CD18E-E1A7-4799-9C10-363867A006BA}">
      <dgm:prSet/>
      <dgm:spPr/>
      <dgm:t>
        <a:bodyPr/>
        <a:lstStyle/>
        <a:p>
          <a:endParaRPr lang="en-US"/>
        </a:p>
      </dgm:t>
    </dgm:pt>
    <dgm:pt modelId="{37618EBB-4645-45F8-AC77-8E49FA2634DC}" type="sibTrans" cxnId="{4F0CD18E-E1A7-4799-9C10-363867A006BA}">
      <dgm:prSet/>
      <dgm:spPr/>
      <dgm:t>
        <a:bodyPr/>
        <a:lstStyle/>
        <a:p>
          <a:endParaRPr lang="en-US"/>
        </a:p>
      </dgm:t>
    </dgm:pt>
    <dgm:pt modelId="{BE654C11-4D7D-4F58-BF9F-A5F852220027}">
      <dgm:prSet custT="1"/>
      <dgm:spPr/>
      <dgm:t>
        <a:bodyPr/>
        <a:lstStyle/>
        <a:p>
          <a:r>
            <a:rPr lang="en-US" sz="1200" dirty="0"/>
            <a:t>No changes in FSH and LH level</a:t>
          </a:r>
        </a:p>
      </dgm:t>
    </dgm:pt>
    <dgm:pt modelId="{C9089358-8327-4E0F-B001-3444CAC550BD}" type="parTrans" cxnId="{C2A16959-8E80-4546-9672-AA49E1CADE8F}">
      <dgm:prSet/>
      <dgm:spPr/>
      <dgm:t>
        <a:bodyPr/>
        <a:lstStyle/>
        <a:p>
          <a:endParaRPr lang="en-US"/>
        </a:p>
      </dgm:t>
    </dgm:pt>
    <dgm:pt modelId="{A8871BB4-C8DC-4B74-A476-965571ED8CF7}" type="sibTrans" cxnId="{C2A16959-8E80-4546-9672-AA49E1CADE8F}">
      <dgm:prSet/>
      <dgm:spPr/>
      <dgm:t>
        <a:bodyPr/>
        <a:lstStyle/>
        <a:p>
          <a:endParaRPr lang="en-US"/>
        </a:p>
      </dgm:t>
    </dgm:pt>
    <dgm:pt modelId="{F048B516-D479-4B13-BC1F-031B3CB5E0DB}">
      <dgm:prSet custT="1"/>
      <dgm:spPr/>
      <dgm:t>
        <a:bodyPr/>
        <a:lstStyle/>
        <a:p>
          <a:r>
            <a:rPr lang="en-US" sz="1200" dirty="0"/>
            <a:t>No changes in testosterone levels </a:t>
          </a:r>
        </a:p>
      </dgm:t>
    </dgm:pt>
    <dgm:pt modelId="{C45FC39E-79CB-4B6C-9AAC-CB5695E39C4A}" type="parTrans" cxnId="{46DFC899-77F5-47F1-9E57-8FC7E69911C0}">
      <dgm:prSet/>
      <dgm:spPr/>
      <dgm:t>
        <a:bodyPr/>
        <a:lstStyle/>
        <a:p>
          <a:endParaRPr lang="en-US"/>
        </a:p>
      </dgm:t>
    </dgm:pt>
    <dgm:pt modelId="{4B230727-BA13-47C8-AFA0-10272508C38E}" type="sibTrans" cxnId="{46DFC899-77F5-47F1-9E57-8FC7E69911C0}">
      <dgm:prSet/>
      <dgm:spPr/>
      <dgm:t>
        <a:bodyPr/>
        <a:lstStyle/>
        <a:p>
          <a:endParaRPr lang="en-US"/>
        </a:p>
      </dgm:t>
    </dgm:pt>
    <dgm:pt modelId="{C8E9C7CD-EEC0-450D-B71A-8C455C85C0B8}" type="pres">
      <dgm:prSet presAssocID="{C8B9B85F-844F-4311-BB51-E10947349E0F}" presName="Name0" presStyleCnt="0">
        <dgm:presLayoutVars>
          <dgm:dir/>
          <dgm:resizeHandles val="exact"/>
        </dgm:presLayoutVars>
      </dgm:prSet>
      <dgm:spPr/>
    </dgm:pt>
    <dgm:pt modelId="{FD5E22C0-B396-44C4-8A95-3F6176A32E81}" type="pres">
      <dgm:prSet presAssocID="{C8B9B85F-844F-4311-BB51-E10947349E0F}" presName="bkgdShp" presStyleLbl="alignAccFollowNode1" presStyleIdx="0" presStyleCnt="1"/>
      <dgm:spPr/>
    </dgm:pt>
    <dgm:pt modelId="{9148A3DB-AC46-46E6-9777-2742F923CA6D}" type="pres">
      <dgm:prSet presAssocID="{C8B9B85F-844F-4311-BB51-E10947349E0F}" presName="linComp" presStyleCnt="0"/>
      <dgm:spPr/>
    </dgm:pt>
    <dgm:pt modelId="{0FC5EEB9-775B-424C-AAEE-3C94631871F0}" type="pres">
      <dgm:prSet presAssocID="{6ECFCC84-17CD-4A09-8702-013585A29B85}" presName="compNode" presStyleCnt="0"/>
      <dgm:spPr/>
    </dgm:pt>
    <dgm:pt modelId="{298E3DDD-742F-471D-8956-2BDA85D5704F}" type="pres">
      <dgm:prSet presAssocID="{6ECFCC84-17CD-4A09-8702-013585A29B85}" presName="node" presStyleLbl="node1" presStyleIdx="0" presStyleCnt="4" custLinFactNeighborX="-529" custLinFactNeighborY="366">
        <dgm:presLayoutVars>
          <dgm:bulletEnabled val="1"/>
        </dgm:presLayoutVars>
      </dgm:prSet>
      <dgm:spPr/>
    </dgm:pt>
    <dgm:pt modelId="{0EFAAE42-5190-47C3-A1BA-3FBEFD4A82A0}" type="pres">
      <dgm:prSet presAssocID="{6ECFCC84-17CD-4A09-8702-013585A29B85}" presName="invisiNode" presStyleLbl="node1" presStyleIdx="0" presStyleCnt="4"/>
      <dgm:spPr/>
    </dgm:pt>
    <dgm:pt modelId="{80292FCD-FECF-4CB8-8A5B-6C0BA5C672DC}" type="pres">
      <dgm:prSet presAssocID="{6ECFCC84-17CD-4A09-8702-013585A29B85}" presName="imagNode" presStyleLbl="fgImgPlace1" presStyleIdx="0" presStyleCnt="4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15000" r="-15000"/>
          </a:stretch>
        </a:blipFill>
      </dgm:spPr>
    </dgm:pt>
    <dgm:pt modelId="{DD8169BA-9C5E-43E0-A230-7576FB90C436}" type="pres">
      <dgm:prSet presAssocID="{1219738F-3160-4F0F-A271-0873CB2F268C}" presName="sibTrans" presStyleLbl="sibTrans2D1" presStyleIdx="0" presStyleCnt="0"/>
      <dgm:spPr/>
    </dgm:pt>
    <dgm:pt modelId="{BF174B43-6C78-4BC1-B86B-5E73D09F1661}" type="pres">
      <dgm:prSet presAssocID="{7B9AAB67-DDD3-4639-860B-619A7ADAEA16}" presName="compNode" presStyleCnt="0"/>
      <dgm:spPr/>
    </dgm:pt>
    <dgm:pt modelId="{52869E26-35C3-4008-BD69-BD8E75C3380D}" type="pres">
      <dgm:prSet presAssocID="{7B9AAB67-DDD3-4639-860B-619A7ADAEA16}" presName="node" presStyleLbl="node1" presStyleIdx="1" presStyleCnt="4">
        <dgm:presLayoutVars>
          <dgm:bulletEnabled val="1"/>
        </dgm:presLayoutVars>
      </dgm:prSet>
      <dgm:spPr/>
    </dgm:pt>
    <dgm:pt modelId="{C1389AF7-3E0B-4BC6-8A9A-C85A9C0A2F7A}" type="pres">
      <dgm:prSet presAssocID="{7B9AAB67-DDD3-4639-860B-619A7ADAEA16}" presName="invisiNode" presStyleLbl="node1" presStyleIdx="1" presStyleCnt="4"/>
      <dgm:spPr/>
    </dgm:pt>
    <dgm:pt modelId="{C5075797-674E-46E9-B43B-E5DE32A70501}" type="pres">
      <dgm:prSet presAssocID="{7B9AAB67-DDD3-4639-860B-619A7ADAEA16}" presName="imagNode" presStyleLbl="fgImgPlace1" presStyleIdx="1" presStyleCnt="4"/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1000" b="-1000"/>
          </a:stretch>
        </a:blipFill>
      </dgm:spPr>
    </dgm:pt>
    <dgm:pt modelId="{09771404-D0BE-47C3-859D-6CDBC3C9CB74}" type="pres">
      <dgm:prSet presAssocID="{D581F235-2DDD-4C3B-A044-C95666420CEE}" presName="sibTrans" presStyleLbl="sibTrans2D1" presStyleIdx="0" presStyleCnt="0"/>
      <dgm:spPr/>
    </dgm:pt>
    <dgm:pt modelId="{2123DF85-5CDB-4E3F-9007-F3F4F87F2404}" type="pres">
      <dgm:prSet presAssocID="{059E22DC-E5C0-49B9-B78D-1ED4F121E156}" presName="compNode" presStyleCnt="0"/>
      <dgm:spPr/>
    </dgm:pt>
    <dgm:pt modelId="{8E857C2D-4E34-4060-9469-B1C4B8797DFE}" type="pres">
      <dgm:prSet presAssocID="{059E22DC-E5C0-49B9-B78D-1ED4F121E156}" presName="node" presStyleLbl="node1" presStyleIdx="2" presStyleCnt="4">
        <dgm:presLayoutVars>
          <dgm:bulletEnabled val="1"/>
        </dgm:presLayoutVars>
      </dgm:prSet>
      <dgm:spPr/>
    </dgm:pt>
    <dgm:pt modelId="{299F0BAD-D5C5-4E68-9240-A51B5D0075A8}" type="pres">
      <dgm:prSet presAssocID="{059E22DC-E5C0-49B9-B78D-1ED4F121E156}" presName="invisiNode" presStyleLbl="node1" presStyleIdx="2" presStyleCnt="4"/>
      <dgm:spPr/>
    </dgm:pt>
    <dgm:pt modelId="{1FC4994D-E818-4BCF-9AB7-01F91FB0FD97}" type="pres">
      <dgm:prSet presAssocID="{059E22DC-E5C0-49B9-B78D-1ED4F121E156}" presName="imagNode" presStyleLbl="fgImgPlace1" presStyleIdx="2" presStyleCnt="4"/>
      <dgm:spPr>
        <a:blipFill dpi="0" rotWithShape="1"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9471" t="114" r="-10529" b="-9063"/>
          </a:stretch>
        </a:blipFill>
      </dgm:spPr>
    </dgm:pt>
    <dgm:pt modelId="{6A3C9F89-2CC4-4B9B-B4E9-C02783F75B73}" type="pres">
      <dgm:prSet presAssocID="{650AACE4-143E-4531-B742-DE38B20A2C40}" presName="sibTrans" presStyleLbl="sibTrans2D1" presStyleIdx="0" presStyleCnt="0"/>
      <dgm:spPr/>
    </dgm:pt>
    <dgm:pt modelId="{149A119B-5E3C-47EF-AD84-517AE8002D80}" type="pres">
      <dgm:prSet presAssocID="{77538CCD-257C-4F6D-8885-50C64322C82F}" presName="compNode" presStyleCnt="0"/>
      <dgm:spPr/>
    </dgm:pt>
    <dgm:pt modelId="{04F84DAC-A812-490E-B9F7-91C2480F621F}" type="pres">
      <dgm:prSet presAssocID="{77538CCD-257C-4F6D-8885-50C64322C82F}" presName="node" presStyleLbl="node1" presStyleIdx="3" presStyleCnt="4">
        <dgm:presLayoutVars>
          <dgm:bulletEnabled val="1"/>
        </dgm:presLayoutVars>
      </dgm:prSet>
      <dgm:spPr/>
    </dgm:pt>
    <dgm:pt modelId="{68C4CE55-78C8-431F-B402-8D4B6E169393}" type="pres">
      <dgm:prSet presAssocID="{77538CCD-257C-4F6D-8885-50C64322C82F}" presName="invisiNode" presStyleLbl="node1" presStyleIdx="3" presStyleCnt="4"/>
      <dgm:spPr/>
    </dgm:pt>
    <dgm:pt modelId="{41DE274A-0B87-4F82-8EBF-80EF4CC0C84C}" type="pres">
      <dgm:prSet presAssocID="{77538CCD-257C-4F6D-8885-50C64322C82F}" presName="imagNode" presStyleLbl="fgImgPlace1" presStyleIdx="3" presStyleCnt="4"/>
      <dgm:spPr>
        <a:blipFill dpi="0" rotWithShape="1"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10471" t="1334" r="-11529" b="-7234"/>
          </a:stretch>
        </a:blipFill>
      </dgm:spPr>
    </dgm:pt>
  </dgm:ptLst>
  <dgm:cxnLst>
    <dgm:cxn modelId="{8BFAF402-F69E-4D8E-8453-AD3C6E8C51E7}" srcId="{7B9AAB67-DDD3-4639-860B-619A7ADAEA16}" destId="{C714CE48-D6BE-47C8-867D-281FF0A35D62}" srcOrd="5" destOrd="0" parTransId="{885AEC9E-3561-495E-8596-6E90281B9C6F}" sibTransId="{27A7CEA4-90AF-4310-BA2C-9169178308A4}"/>
    <dgm:cxn modelId="{34049809-3C1F-46FF-8338-33E4A04AA750}" type="presOf" srcId="{31BA1495-1F57-4A84-80CD-D39B0590163B}" destId="{298E3DDD-742F-471D-8956-2BDA85D5704F}" srcOrd="0" destOrd="7" presId="urn:microsoft.com/office/officeart/2005/8/layout/pList2"/>
    <dgm:cxn modelId="{DA09830C-D066-44C0-92A5-FF797521D914}" type="presOf" srcId="{65211C4B-89D9-4ABF-88B2-A4DB4F210F21}" destId="{52869E26-35C3-4008-BD69-BD8E75C3380D}" srcOrd="0" destOrd="7" presId="urn:microsoft.com/office/officeart/2005/8/layout/pList2"/>
    <dgm:cxn modelId="{3D27880D-02B7-4B52-B834-DCBD940DE5ED}" srcId="{77538CCD-257C-4F6D-8885-50C64322C82F}" destId="{96365B3E-A9F4-4C8E-A8C1-B7DCE6C0915C}" srcOrd="1" destOrd="0" parTransId="{1BEBFD84-1988-4960-BDB0-26407CB69913}" sibTransId="{3F707618-A1A8-4EF4-9B2C-53E2A1DAEAFB}"/>
    <dgm:cxn modelId="{0DA1AF10-9FA0-4B01-BE3A-277284B5B0CF}" type="presOf" srcId="{BE654C11-4D7D-4F58-BF9F-A5F852220027}" destId="{298E3DDD-742F-471D-8956-2BDA85D5704F}" srcOrd="0" destOrd="3" presId="urn:microsoft.com/office/officeart/2005/8/layout/pList2"/>
    <dgm:cxn modelId="{E0A08A16-2F70-411C-A4B7-0C9643BB36EC}" srcId="{7B9AAB67-DDD3-4639-860B-619A7ADAEA16}" destId="{A3F4D300-8B3F-4E0A-A359-122E7D86F4B4}" srcOrd="0" destOrd="0" parTransId="{984951E1-CD2D-4AA0-99F2-FA66EC0B7C4D}" sibTransId="{09326B66-C578-480B-831B-29E92A32F533}"/>
    <dgm:cxn modelId="{EC0D1C19-4EBD-45A9-9531-6001951819A5}" type="presOf" srcId="{6D4A96F1-F584-46DC-B270-FD6F2A173748}" destId="{04F84DAC-A812-490E-B9F7-91C2480F621F}" srcOrd="0" destOrd="4" presId="urn:microsoft.com/office/officeart/2005/8/layout/pList2"/>
    <dgm:cxn modelId="{5067A51A-4F3B-43EF-B139-38D3BB52DDB9}" type="presOf" srcId="{8873D990-7EC3-452C-AA3B-935913CCD64B}" destId="{52869E26-35C3-4008-BD69-BD8E75C3380D}" srcOrd="0" destOrd="2" presId="urn:microsoft.com/office/officeart/2005/8/layout/pList2"/>
    <dgm:cxn modelId="{F2181C1B-D854-4636-8665-41EE5B05415F}" srcId="{6ECFCC84-17CD-4A09-8702-013585A29B85}" destId="{2996153D-AC5D-4677-9FB4-E6F3EE72E7CA}" srcOrd="5" destOrd="0" parTransId="{B37B98D0-8548-4F32-85D0-F8D8E0E06386}" sibTransId="{7736A0D5-FB09-4BC2-8FB0-F80F6F6F204A}"/>
    <dgm:cxn modelId="{1233C41B-C27A-41B9-A45A-EEE66DC4BF3D}" type="presOf" srcId="{CB9A3220-9BA1-40CA-A27C-A05772717882}" destId="{52869E26-35C3-4008-BD69-BD8E75C3380D}" srcOrd="0" destOrd="8" presId="urn:microsoft.com/office/officeart/2005/8/layout/pList2"/>
    <dgm:cxn modelId="{0C97071E-D9A7-49F8-B73B-BC558B56556F}" srcId="{6ECFCC84-17CD-4A09-8702-013585A29B85}" destId="{31BA1495-1F57-4A84-80CD-D39B0590163B}" srcOrd="6" destOrd="0" parTransId="{C69104B2-1949-4226-941E-D539A333956C}" sibTransId="{DD5DE76C-96DE-4C8B-8870-F339498E9F8E}"/>
    <dgm:cxn modelId="{3D656D23-BBEA-4AAA-ABE4-9A7FC2C28264}" srcId="{C8B9B85F-844F-4311-BB51-E10947349E0F}" destId="{7B9AAB67-DDD3-4639-860B-619A7ADAEA16}" srcOrd="1" destOrd="0" parTransId="{9426FE76-1CB5-4D0A-BBF4-49CA62519CA8}" sibTransId="{D581F235-2DDD-4C3B-A044-C95666420CEE}"/>
    <dgm:cxn modelId="{1CF86128-66BB-414A-BCFE-AC5B97C96716}" srcId="{7B9AAB67-DDD3-4639-860B-619A7ADAEA16}" destId="{91B0690A-F0FE-41AD-8B2B-8CEB458BD515}" srcOrd="3" destOrd="0" parTransId="{8686FB7B-A1B7-4BE4-A380-A4FE28BAA634}" sibTransId="{16A31D07-FB99-4344-A345-8A8299EB5AEA}"/>
    <dgm:cxn modelId="{B93D6429-DAD6-465E-AB8F-6B3F2E294D8A}" type="presOf" srcId="{96365B3E-A9F4-4C8E-A8C1-B7DCE6C0915C}" destId="{04F84DAC-A812-490E-B9F7-91C2480F621F}" srcOrd="0" destOrd="2" presId="urn:microsoft.com/office/officeart/2005/8/layout/pList2"/>
    <dgm:cxn modelId="{C022F82F-83DF-43A6-8080-5A1D87FC43A9}" type="presOf" srcId="{2996153D-AC5D-4677-9FB4-E6F3EE72E7CA}" destId="{298E3DDD-742F-471D-8956-2BDA85D5704F}" srcOrd="0" destOrd="6" presId="urn:microsoft.com/office/officeart/2005/8/layout/pList2"/>
    <dgm:cxn modelId="{EE18DC38-07AF-4288-A192-64DFB61402BE}" type="presOf" srcId="{2BD618A9-AC49-4E19-83B7-51676688B442}" destId="{298E3DDD-742F-471D-8956-2BDA85D5704F}" srcOrd="0" destOrd="5" presId="urn:microsoft.com/office/officeart/2005/8/layout/pList2"/>
    <dgm:cxn modelId="{6CF34339-968F-4D96-9345-912BEBD4CA16}" type="presOf" srcId="{D1986E71-B33B-4FAC-BB57-4B5CAFFB3491}" destId="{52869E26-35C3-4008-BD69-BD8E75C3380D}" srcOrd="0" destOrd="3" presId="urn:microsoft.com/office/officeart/2005/8/layout/pList2"/>
    <dgm:cxn modelId="{DDE16240-B398-4E38-B65A-1043A3881B25}" type="presOf" srcId="{1219738F-3160-4F0F-A271-0873CB2F268C}" destId="{DD8169BA-9C5E-43E0-A230-7576FB90C436}" srcOrd="0" destOrd="0" presId="urn:microsoft.com/office/officeart/2005/8/layout/pList2"/>
    <dgm:cxn modelId="{C72B175F-33ED-4BB2-AB56-084520751707}" srcId="{059E22DC-E5C0-49B9-B78D-1ED4F121E156}" destId="{F8594DF8-C229-4BE1-BD62-9EE1CE68AFBF}" srcOrd="0" destOrd="0" parTransId="{43F208CA-3A39-443C-885A-0D871C7D5B9C}" sibTransId="{C90ACB1B-57A5-4221-B4C7-A7FFCB21EB4D}"/>
    <dgm:cxn modelId="{7782AC63-DA4E-433B-ACB0-32CC7F59D9E5}" srcId="{77538CCD-257C-4F6D-8885-50C64322C82F}" destId="{A9E892F1-BAA2-4DC0-AB0B-E151F3826843}" srcOrd="0" destOrd="0" parTransId="{7329DF87-68A4-47FD-A197-D450034B7141}" sibTransId="{3129492F-843F-4E07-AEC9-2214A6F9F494}"/>
    <dgm:cxn modelId="{1B72B767-EC6A-4D5F-8C98-C2D11752F076}" srcId="{7B9AAB67-DDD3-4639-860B-619A7ADAEA16}" destId="{EA9EFB14-F694-4DA2-BB92-7FA2FE079CF5}" srcOrd="4" destOrd="0" parTransId="{49899EEC-83D0-42C5-A4E4-8070FFAE8159}" sibTransId="{CF3E91CB-51A1-48C9-BAF0-329F712C2C32}"/>
    <dgm:cxn modelId="{306C4E4A-F379-4D11-9C3C-0094029FD2EA}" srcId="{7B9AAB67-DDD3-4639-860B-619A7ADAEA16}" destId="{CB9A3220-9BA1-40CA-A27C-A05772717882}" srcOrd="7" destOrd="0" parTransId="{9F147C10-D824-4C6F-B656-C0238B952D95}" sibTransId="{6DB0D7D1-B297-489F-849E-97192EE6D0C7}"/>
    <dgm:cxn modelId="{8D726B4D-3EBA-46B9-BEBA-24FF5EF4A3FE}" srcId="{059E22DC-E5C0-49B9-B78D-1ED4F121E156}" destId="{E16B6CD2-DF67-4D37-B15E-B6BBAD16AB23}" srcOrd="3" destOrd="0" parTransId="{12F94176-07E0-4646-AE56-607DB14FC676}" sibTransId="{E87B321C-2B96-4DB5-9339-CF6C7F39D333}"/>
    <dgm:cxn modelId="{A62CF471-1A4E-455F-9FFA-9D81122D194D}" type="presOf" srcId="{77538CCD-257C-4F6D-8885-50C64322C82F}" destId="{04F84DAC-A812-490E-B9F7-91C2480F621F}" srcOrd="0" destOrd="0" presId="urn:microsoft.com/office/officeart/2005/8/layout/pList2"/>
    <dgm:cxn modelId="{1CACE472-BAAF-4C23-AE47-671998A4D1B0}" srcId="{7B9AAB67-DDD3-4639-860B-619A7ADAEA16}" destId="{65211C4B-89D9-4ABF-88B2-A4DB4F210F21}" srcOrd="6" destOrd="0" parTransId="{D598EFE6-B830-4B96-981E-F4788F8DCD87}" sibTransId="{494788BD-0936-4BB4-B91B-1FE34CF94B05}"/>
    <dgm:cxn modelId="{82500E75-DA22-4B8C-A463-DB33CAD2AD61}" type="presOf" srcId="{249A57EF-E067-43D5-8021-9A741118244D}" destId="{04F84DAC-A812-490E-B9F7-91C2480F621F}" srcOrd="0" destOrd="5" presId="urn:microsoft.com/office/officeart/2005/8/layout/pList2"/>
    <dgm:cxn modelId="{AA57B858-B36E-4329-83FC-2C69EAA8C131}" type="presOf" srcId="{6ECFCC84-17CD-4A09-8702-013585A29B85}" destId="{298E3DDD-742F-471D-8956-2BDA85D5704F}" srcOrd="0" destOrd="0" presId="urn:microsoft.com/office/officeart/2005/8/layout/pList2"/>
    <dgm:cxn modelId="{9A952679-4E4F-4609-9866-36B065BF5265}" srcId="{7B9AAB67-DDD3-4639-860B-619A7ADAEA16}" destId="{8873D990-7EC3-452C-AA3B-935913CCD64B}" srcOrd="1" destOrd="0" parTransId="{6E7AB4E0-5EFE-481C-94EB-8E485F478F64}" sibTransId="{1497520C-068E-47AB-8685-699E8DF86333}"/>
    <dgm:cxn modelId="{C2A16959-8E80-4546-9672-AA49E1CADE8F}" srcId="{6ECFCC84-17CD-4A09-8702-013585A29B85}" destId="{BE654C11-4D7D-4F58-BF9F-A5F852220027}" srcOrd="2" destOrd="0" parTransId="{C9089358-8327-4E0F-B001-3444CAC550BD}" sibTransId="{A8871BB4-C8DC-4B74-A476-965571ED8CF7}"/>
    <dgm:cxn modelId="{220CFB7B-F0C7-42A7-B030-B4B1AEC06E21}" srcId="{77538CCD-257C-4F6D-8885-50C64322C82F}" destId="{6D4A96F1-F584-46DC-B270-FD6F2A173748}" srcOrd="3" destOrd="0" parTransId="{386E638A-517A-427E-A4AC-9E0F3EF40DC4}" sibTransId="{D30BCA6F-B04E-439C-A600-A78F990AE634}"/>
    <dgm:cxn modelId="{1E0A0B7F-6BD5-461E-A445-FCC3503551BD}" srcId="{059E22DC-E5C0-49B9-B78D-1ED4F121E156}" destId="{C07AF31F-C3D3-410C-A0EB-BC7137A710BD}" srcOrd="2" destOrd="0" parTransId="{3201EBEB-2821-4CB0-AD45-F2B7736CAFB2}" sibTransId="{4E786301-B378-46A4-9F02-AC2F410ECB1F}"/>
    <dgm:cxn modelId="{676DFB87-4352-4C79-9667-D05E505F2737}" type="presOf" srcId="{A9E892F1-BAA2-4DC0-AB0B-E151F3826843}" destId="{04F84DAC-A812-490E-B9F7-91C2480F621F}" srcOrd="0" destOrd="1" presId="urn:microsoft.com/office/officeart/2005/8/layout/pList2"/>
    <dgm:cxn modelId="{8A7A6088-6C76-4302-B1DA-A8B97C31D3C9}" type="presOf" srcId="{C8B9B85F-844F-4311-BB51-E10947349E0F}" destId="{C8E9C7CD-EEC0-450D-B71A-8C455C85C0B8}" srcOrd="0" destOrd="0" presId="urn:microsoft.com/office/officeart/2005/8/layout/pList2"/>
    <dgm:cxn modelId="{185B0C89-C641-40AD-8F7F-A41A924F6154}" type="presOf" srcId="{F8594DF8-C229-4BE1-BD62-9EE1CE68AFBF}" destId="{8E857C2D-4E34-4060-9469-B1C4B8797DFE}" srcOrd="0" destOrd="1" presId="urn:microsoft.com/office/officeart/2005/8/layout/pList2"/>
    <dgm:cxn modelId="{7DD99C89-2ABD-4957-B0A4-13F43F0712C1}" srcId="{059E22DC-E5C0-49B9-B78D-1ED4F121E156}" destId="{698DBBC0-9979-41C9-996D-D211B1D30E0D}" srcOrd="1" destOrd="0" parTransId="{43EEF37B-9669-4AE4-AD8E-B870BE4DAB7A}" sibTransId="{3154FB6C-A7FA-4D0B-A359-AA2BE43EE9A9}"/>
    <dgm:cxn modelId="{0BDB818E-145E-4746-AEF0-C2631F810393}" type="presOf" srcId="{EA9EFB14-F694-4DA2-BB92-7FA2FE079CF5}" destId="{52869E26-35C3-4008-BD69-BD8E75C3380D}" srcOrd="0" destOrd="5" presId="urn:microsoft.com/office/officeart/2005/8/layout/pList2"/>
    <dgm:cxn modelId="{4F0CD18E-E1A7-4799-9C10-363867A006BA}" srcId="{6ECFCC84-17CD-4A09-8702-013585A29B85}" destId="{2BD618A9-AC49-4E19-83B7-51676688B442}" srcOrd="4" destOrd="0" parTransId="{4BB0327C-7263-466D-8D7F-4D1DB2A32C30}" sibTransId="{37618EBB-4645-45F8-AC77-8E49FA2634DC}"/>
    <dgm:cxn modelId="{D945528F-B6A2-499F-A0D7-5F6CA3BBA58A}" type="presOf" srcId="{C07AF31F-C3D3-410C-A0EB-BC7137A710BD}" destId="{8E857C2D-4E34-4060-9469-B1C4B8797DFE}" srcOrd="0" destOrd="3" presId="urn:microsoft.com/office/officeart/2005/8/layout/pList2"/>
    <dgm:cxn modelId="{8BFDF891-41AD-4F16-87BB-E1C16350F288}" srcId="{77538CCD-257C-4F6D-8885-50C64322C82F}" destId="{249A57EF-E067-43D5-8021-9A741118244D}" srcOrd="4" destOrd="0" parTransId="{FFF49758-E759-4940-BC82-1165FB5E2EBD}" sibTransId="{DE264E2C-C557-42FD-9D24-FDBCF8B7DC93}"/>
    <dgm:cxn modelId="{46DFC899-77F5-47F1-9E57-8FC7E69911C0}" srcId="{6ECFCC84-17CD-4A09-8702-013585A29B85}" destId="{F048B516-D479-4B13-BC1F-031B3CB5E0DB}" srcOrd="3" destOrd="0" parTransId="{C45FC39E-79CB-4B6C-9AAC-CB5695E39C4A}" sibTransId="{4B230727-BA13-47C8-AFA0-10272508C38E}"/>
    <dgm:cxn modelId="{8E1BF899-9C65-44D6-A6EB-11C73E2756A6}" srcId="{77538CCD-257C-4F6D-8885-50C64322C82F}" destId="{ABF06B23-0317-49B6-9A1A-F48B33C976A8}" srcOrd="2" destOrd="0" parTransId="{B41B659F-1784-4409-BF7A-1D47ADD32837}" sibTransId="{88B80D8F-FB59-4CA8-8420-E9CC93E44910}"/>
    <dgm:cxn modelId="{9DB8AEA0-0156-4BEA-ADC1-58A0D05B5701}" type="presOf" srcId="{E16B6CD2-DF67-4D37-B15E-B6BBAD16AB23}" destId="{8E857C2D-4E34-4060-9469-B1C4B8797DFE}" srcOrd="0" destOrd="4" presId="urn:microsoft.com/office/officeart/2005/8/layout/pList2"/>
    <dgm:cxn modelId="{61A284A1-C86D-4BA7-9428-5B05431C4CC3}" srcId="{6ECFCC84-17CD-4A09-8702-013585A29B85}" destId="{0551C229-4671-4B10-A40D-92F7E52EE9ED}" srcOrd="0" destOrd="0" parTransId="{A5E84AC7-23AD-4673-BFD3-305AC45CE678}" sibTransId="{65FD06B1-DD58-4255-92A3-D225A0CDC9CB}"/>
    <dgm:cxn modelId="{85A48FA1-7AAF-4B9E-89E8-B8A402E47B55}" type="presOf" srcId="{7B9AAB67-DDD3-4639-860B-619A7ADAEA16}" destId="{52869E26-35C3-4008-BD69-BD8E75C3380D}" srcOrd="0" destOrd="0" presId="urn:microsoft.com/office/officeart/2005/8/layout/pList2"/>
    <dgm:cxn modelId="{7BD8EBA9-162D-4743-92E2-1ECD427AB285}" srcId="{7B9AAB67-DDD3-4639-860B-619A7ADAEA16}" destId="{D1986E71-B33B-4FAC-BB57-4B5CAFFB3491}" srcOrd="2" destOrd="0" parTransId="{468EEE1C-14D9-4929-B985-E47874BBC43A}" sibTransId="{2A6F93F6-63E7-48E2-8A8A-389D939B2315}"/>
    <dgm:cxn modelId="{B0AAF9BE-C096-4377-81C6-63A269C49B6C}" type="presOf" srcId="{D581F235-2DDD-4C3B-A044-C95666420CEE}" destId="{09771404-D0BE-47C3-859D-6CDBC3C9CB74}" srcOrd="0" destOrd="0" presId="urn:microsoft.com/office/officeart/2005/8/layout/pList2"/>
    <dgm:cxn modelId="{CBFC22C1-0FBC-44C0-8C23-3CAB57D3569F}" type="presOf" srcId="{698DBBC0-9979-41C9-996D-D211B1D30E0D}" destId="{8E857C2D-4E34-4060-9469-B1C4B8797DFE}" srcOrd="0" destOrd="2" presId="urn:microsoft.com/office/officeart/2005/8/layout/pList2"/>
    <dgm:cxn modelId="{E92CACC2-138F-40FD-96E1-CF5824B81970}" type="presOf" srcId="{0551C229-4671-4B10-A40D-92F7E52EE9ED}" destId="{298E3DDD-742F-471D-8956-2BDA85D5704F}" srcOrd="0" destOrd="1" presId="urn:microsoft.com/office/officeart/2005/8/layout/pList2"/>
    <dgm:cxn modelId="{7257FDC5-6D3F-47BC-AEFF-672229FFA458}" type="presOf" srcId="{A3F4D300-8B3F-4E0A-A359-122E7D86F4B4}" destId="{52869E26-35C3-4008-BD69-BD8E75C3380D}" srcOrd="0" destOrd="1" presId="urn:microsoft.com/office/officeart/2005/8/layout/pList2"/>
    <dgm:cxn modelId="{D64B60C8-C025-4D51-94F2-DFAF9F020959}" type="presOf" srcId="{059E22DC-E5C0-49B9-B78D-1ED4F121E156}" destId="{8E857C2D-4E34-4060-9469-B1C4B8797DFE}" srcOrd="0" destOrd="0" presId="urn:microsoft.com/office/officeart/2005/8/layout/pList2"/>
    <dgm:cxn modelId="{CCC2DACB-D79A-40A9-B05D-2090A4498F3D}" srcId="{059E22DC-E5C0-49B9-B78D-1ED4F121E156}" destId="{A1669F18-1E4A-47F1-ACEB-A4AA8F0ABC19}" srcOrd="4" destOrd="0" parTransId="{C4FBBD02-0E12-406A-AD98-2A02F400C4F0}" sibTransId="{BC831E95-FBAB-4CA4-87E5-92D58E991656}"/>
    <dgm:cxn modelId="{61DAA5D1-C008-4B0A-B5AD-DDE9F50D4C6C}" srcId="{C8B9B85F-844F-4311-BB51-E10947349E0F}" destId="{77538CCD-257C-4F6D-8885-50C64322C82F}" srcOrd="3" destOrd="0" parTransId="{B2601949-CF72-4FD5-9444-DB7AB9441CCB}" sibTransId="{7444D001-CADE-40CC-B46C-C33E1876C50A}"/>
    <dgm:cxn modelId="{B826B1D1-FD58-4986-B85F-D8153014091D}" type="presOf" srcId="{C714CE48-D6BE-47C8-867D-281FF0A35D62}" destId="{52869E26-35C3-4008-BD69-BD8E75C3380D}" srcOrd="0" destOrd="6" presId="urn:microsoft.com/office/officeart/2005/8/layout/pList2"/>
    <dgm:cxn modelId="{7BEDAFD4-C656-4053-BDFC-3A74060E7958}" type="presOf" srcId="{91B0690A-F0FE-41AD-8B2B-8CEB458BD515}" destId="{52869E26-35C3-4008-BD69-BD8E75C3380D}" srcOrd="0" destOrd="4" presId="urn:microsoft.com/office/officeart/2005/8/layout/pList2"/>
    <dgm:cxn modelId="{FCB2E3D9-039A-4C3A-8903-7CB10EDCDE39}" srcId="{C8B9B85F-844F-4311-BB51-E10947349E0F}" destId="{059E22DC-E5C0-49B9-B78D-1ED4F121E156}" srcOrd="2" destOrd="0" parTransId="{67B16BBF-B796-441E-872F-05557CB413C9}" sibTransId="{650AACE4-143E-4531-B742-DE38B20A2C40}"/>
    <dgm:cxn modelId="{1659C4DC-CBB9-4936-8785-932BE7FB336C}" type="presOf" srcId="{650AACE4-143E-4531-B742-DE38B20A2C40}" destId="{6A3C9F89-2CC4-4B9B-B4E9-C02783F75B73}" srcOrd="0" destOrd="0" presId="urn:microsoft.com/office/officeart/2005/8/layout/pList2"/>
    <dgm:cxn modelId="{161208DE-20F3-4D54-95CB-FB8E7264BB9E}" type="presOf" srcId="{FD85822D-7FC3-4D15-B0AD-B84E36EFDB27}" destId="{298E3DDD-742F-471D-8956-2BDA85D5704F}" srcOrd="0" destOrd="2" presId="urn:microsoft.com/office/officeart/2005/8/layout/pList2"/>
    <dgm:cxn modelId="{3FC929E0-ADC3-4CED-BCE8-8358AD9497AF}" type="presOf" srcId="{ABF06B23-0317-49B6-9A1A-F48B33C976A8}" destId="{04F84DAC-A812-490E-B9F7-91C2480F621F}" srcOrd="0" destOrd="3" presId="urn:microsoft.com/office/officeart/2005/8/layout/pList2"/>
    <dgm:cxn modelId="{B4176AE8-5BFE-46C1-AC42-F139FD2AA1C0}" type="presOf" srcId="{A1669F18-1E4A-47F1-ACEB-A4AA8F0ABC19}" destId="{8E857C2D-4E34-4060-9469-B1C4B8797DFE}" srcOrd="0" destOrd="5" presId="urn:microsoft.com/office/officeart/2005/8/layout/pList2"/>
    <dgm:cxn modelId="{357EF9F2-0727-458E-8268-2A75A6106B36}" srcId="{C8B9B85F-844F-4311-BB51-E10947349E0F}" destId="{6ECFCC84-17CD-4A09-8702-013585A29B85}" srcOrd="0" destOrd="0" parTransId="{F0B8FC48-046E-4F13-BB24-0A64605A5CED}" sibTransId="{1219738F-3160-4F0F-A271-0873CB2F268C}"/>
    <dgm:cxn modelId="{353459FE-C67A-43CF-B89D-2CD7E19E9C93}" srcId="{6ECFCC84-17CD-4A09-8702-013585A29B85}" destId="{FD85822D-7FC3-4D15-B0AD-B84E36EFDB27}" srcOrd="1" destOrd="0" parTransId="{9B40B9F0-51E5-4DB3-BEE1-CA3C0A58BD7C}" sibTransId="{687FBBE4-D94C-453C-AF69-60B8F0E31325}"/>
    <dgm:cxn modelId="{E0662CFF-BAFB-407E-BC35-3E2759FAA5FD}" type="presOf" srcId="{F048B516-D479-4B13-BC1F-031B3CB5E0DB}" destId="{298E3DDD-742F-471D-8956-2BDA85D5704F}" srcOrd="0" destOrd="4" presId="urn:microsoft.com/office/officeart/2005/8/layout/pList2"/>
    <dgm:cxn modelId="{3A596690-8585-4C68-92B4-1875C91C0F8E}" type="presParOf" srcId="{C8E9C7CD-EEC0-450D-B71A-8C455C85C0B8}" destId="{FD5E22C0-B396-44C4-8A95-3F6176A32E81}" srcOrd="0" destOrd="0" presId="urn:microsoft.com/office/officeart/2005/8/layout/pList2"/>
    <dgm:cxn modelId="{635FDDE7-5B31-4162-8BDB-0A390453ABBB}" type="presParOf" srcId="{C8E9C7CD-EEC0-450D-B71A-8C455C85C0B8}" destId="{9148A3DB-AC46-46E6-9777-2742F923CA6D}" srcOrd="1" destOrd="0" presId="urn:microsoft.com/office/officeart/2005/8/layout/pList2"/>
    <dgm:cxn modelId="{9C310967-2657-4308-869D-11B1D0D5F080}" type="presParOf" srcId="{9148A3DB-AC46-46E6-9777-2742F923CA6D}" destId="{0FC5EEB9-775B-424C-AAEE-3C94631871F0}" srcOrd="0" destOrd="0" presId="urn:microsoft.com/office/officeart/2005/8/layout/pList2"/>
    <dgm:cxn modelId="{5B63078A-72A9-4148-8F18-8C2893FF890E}" type="presParOf" srcId="{0FC5EEB9-775B-424C-AAEE-3C94631871F0}" destId="{298E3DDD-742F-471D-8956-2BDA85D5704F}" srcOrd="0" destOrd="0" presId="urn:microsoft.com/office/officeart/2005/8/layout/pList2"/>
    <dgm:cxn modelId="{4D1CC170-B9F4-4308-AE37-CFD7B761C63E}" type="presParOf" srcId="{0FC5EEB9-775B-424C-AAEE-3C94631871F0}" destId="{0EFAAE42-5190-47C3-A1BA-3FBEFD4A82A0}" srcOrd="1" destOrd="0" presId="urn:microsoft.com/office/officeart/2005/8/layout/pList2"/>
    <dgm:cxn modelId="{EDD2BC7B-B1F4-409F-9735-12F6B51F0AB3}" type="presParOf" srcId="{0FC5EEB9-775B-424C-AAEE-3C94631871F0}" destId="{80292FCD-FECF-4CB8-8A5B-6C0BA5C672DC}" srcOrd="2" destOrd="0" presId="urn:microsoft.com/office/officeart/2005/8/layout/pList2"/>
    <dgm:cxn modelId="{052DFE50-CAB2-483E-941A-49DC308C6C85}" type="presParOf" srcId="{9148A3DB-AC46-46E6-9777-2742F923CA6D}" destId="{DD8169BA-9C5E-43E0-A230-7576FB90C436}" srcOrd="1" destOrd="0" presId="urn:microsoft.com/office/officeart/2005/8/layout/pList2"/>
    <dgm:cxn modelId="{C3FE1F0B-F89E-41C0-811F-8D5AF41F880A}" type="presParOf" srcId="{9148A3DB-AC46-46E6-9777-2742F923CA6D}" destId="{BF174B43-6C78-4BC1-B86B-5E73D09F1661}" srcOrd="2" destOrd="0" presId="urn:microsoft.com/office/officeart/2005/8/layout/pList2"/>
    <dgm:cxn modelId="{B593171F-713F-47D5-88F1-DBC28EA1B3FA}" type="presParOf" srcId="{BF174B43-6C78-4BC1-B86B-5E73D09F1661}" destId="{52869E26-35C3-4008-BD69-BD8E75C3380D}" srcOrd="0" destOrd="0" presId="urn:microsoft.com/office/officeart/2005/8/layout/pList2"/>
    <dgm:cxn modelId="{1D3AB566-4FA4-4FFE-940C-5F9E373852A6}" type="presParOf" srcId="{BF174B43-6C78-4BC1-B86B-5E73D09F1661}" destId="{C1389AF7-3E0B-4BC6-8A9A-C85A9C0A2F7A}" srcOrd="1" destOrd="0" presId="urn:microsoft.com/office/officeart/2005/8/layout/pList2"/>
    <dgm:cxn modelId="{40932773-5EEF-4051-9E70-9BB494308B2B}" type="presParOf" srcId="{BF174B43-6C78-4BC1-B86B-5E73D09F1661}" destId="{C5075797-674E-46E9-B43B-E5DE32A70501}" srcOrd="2" destOrd="0" presId="urn:microsoft.com/office/officeart/2005/8/layout/pList2"/>
    <dgm:cxn modelId="{F6636EF4-1A49-4FCA-8B10-DE91F4DE468C}" type="presParOf" srcId="{9148A3DB-AC46-46E6-9777-2742F923CA6D}" destId="{09771404-D0BE-47C3-859D-6CDBC3C9CB74}" srcOrd="3" destOrd="0" presId="urn:microsoft.com/office/officeart/2005/8/layout/pList2"/>
    <dgm:cxn modelId="{24098BED-0E26-4028-9311-AB4BEA504AD2}" type="presParOf" srcId="{9148A3DB-AC46-46E6-9777-2742F923CA6D}" destId="{2123DF85-5CDB-4E3F-9007-F3F4F87F2404}" srcOrd="4" destOrd="0" presId="urn:microsoft.com/office/officeart/2005/8/layout/pList2"/>
    <dgm:cxn modelId="{0B4F4C8A-6273-453C-BAEE-26B624D5BABA}" type="presParOf" srcId="{2123DF85-5CDB-4E3F-9007-F3F4F87F2404}" destId="{8E857C2D-4E34-4060-9469-B1C4B8797DFE}" srcOrd="0" destOrd="0" presId="urn:microsoft.com/office/officeart/2005/8/layout/pList2"/>
    <dgm:cxn modelId="{52619FB2-BED4-49C0-AB48-23E1152912F8}" type="presParOf" srcId="{2123DF85-5CDB-4E3F-9007-F3F4F87F2404}" destId="{299F0BAD-D5C5-4E68-9240-A51B5D0075A8}" srcOrd="1" destOrd="0" presId="urn:microsoft.com/office/officeart/2005/8/layout/pList2"/>
    <dgm:cxn modelId="{78159EAC-4FF7-4909-B3E1-CF2E950BC9CC}" type="presParOf" srcId="{2123DF85-5CDB-4E3F-9007-F3F4F87F2404}" destId="{1FC4994D-E818-4BCF-9AB7-01F91FB0FD97}" srcOrd="2" destOrd="0" presId="urn:microsoft.com/office/officeart/2005/8/layout/pList2"/>
    <dgm:cxn modelId="{0B947EDA-1924-4DA2-A7E4-EA0F1BECE739}" type="presParOf" srcId="{9148A3DB-AC46-46E6-9777-2742F923CA6D}" destId="{6A3C9F89-2CC4-4B9B-B4E9-C02783F75B73}" srcOrd="5" destOrd="0" presId="urn:microsoft.com/office/officeart/2005/8/layout/pList2"/>
    <dgm:cxn modelId="{F4B9EC43-590F-4D4A-96E0-1E48A84CCE5B}" type="presParOf" srcId="{9148A3DB-AC46-46E6-9777-2742F923CA6D}" destId="{149A119B-5E3C-47EF-AD84-517AE8002D80}" srcOrd="6" destOrd="0" presId="urn:microsoft.com/office/officeart/2005/8/layout/pList2"/>
    <dgm:cxn modelId="{BDD7385D-0D1B-4305-B689-14ECDFC09608}" type="presParOf" srcId="{149A119B-5E3C-47EF-AD84-517AE8002D80}" destId="{04F84DAC-A812-490E-B9F7-91C2480F621F}" srcOrd="0" destOrd="0" presId="urn:microsoft.com/office/officeart/2005/8/layout/pList2"/>
    <dgm:cxn modelId="{6CE1D23B-3D7D-4684-B6CD-EDC0008AC3EC}" type="presParOf" srcId="{149A119B-5E3C-47EF-AD84-517AE8002D80}" destId="{68C4CE55-78C8-431F-B402-8D4B6E169393}" srcOrd="1" destOrd="0" presId="urn:microsoft.com/office/officeart/2005/8/layout/pList2"/>
    <dgm:cxn modelId="{D89A8F97-DCD8-4DFB-8AF0-DFC8B89121DB}" type="presParOf" srcId="{149A119B-5E3C-47EF-AD84-517AE8002D80}" destId="{41DE274A-0B87-4F82-8EBF-80EF4CC0C84C}" srcOrd="2" destOrd="0" presId="urn:microsoft.com/office/officeart/2005/8/layout/p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5E22C0-B396-44C4-8A95-3F6176A32E81}">
      <dsp:nvSpPr>
        <dsp:cNvPr id="0" name=""/>
        <dsp:cNvSpPr/>
      </dsp:nvSpPr>
      <dsp:spPr>
        <a:xfrm>
          <a:off x="0" y="0"/>
          <a:ext cx="8069943" cy="2086246"/>
        </a:xfrm>
        <a:prstGeom prst="roundRect">
          <a:avLst>
            <a:gd name="adj" fmla="val 1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0292FCD-FECF-4CB8-8A5B-6C0BA5C672DC}">
      <dsp:nvSpPr>
        <dsp:cNvPr id="0" name=""/>
        <dsp:cNvSpPr/>
      </dsp:nvSpPr>
      <dsp:spPr>
        <a:xfrm>
          <a:off x="244320" y="278166"/>
          <a:ext cx="1763093" cy="1529914"/>
        </a:xfrm>
        <a:prstGeom prst="roundRect">
          <a:avLst>
            <a:gd name="adj" fmla="val 10000"/>
          </a:avLst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15000" r="-15000"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8E3DDD-742F-471D-8956-2BDA85D5704F}">
      <dsp:nvSpPr>
        <dsp:cNvPr id="0" name=""/>
        <dsp:cNvSpPr/>
      </dsp:nvSpPr>
      <dsp:spPr>
        <a:xfrm rot="10800000">
          <a:off x="234993" y="2086246"/>
          <a:ext cx="1763093" cy="2549857"/>
        </a:xfrm>
        <a:prstGeom prst="round2SameRect">
          <a:avLst>
            <a:gd name="adj1" fmla="val 10500"/>
            <a:gd name="adj2" fmla="val 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3792" tIns="113792" rIns="113792" bIns="113792" numCol="1" spcCol="1270" anchor="t" anchorCtr="0">
          <a:noAutofit/>
        </a:bodyPr>
        <a:lstStyle/>
        <a:p>
          <a:pPr marL="0" lvl="0" indent="0" algn="l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changes in weight and BMI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changes in insulin resistance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changes in FSH and LH level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changes in testosterone levels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2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</dsp:txBody>
      <dsp:txXfrm rot="10800000">
        <a:off x="289214" y="2086246"/>
        <a:ext cx="1654651" cy="2495636"/>
      </dsp:txXfrm>
    </dsp:sp>
    <dsp:sp modelId="{C5075797-674E-46E9-B43B-E5DE32A70501}">
      <dsp:nvSpPr>
        <dsp:cNvPr id="0" name=""/>
        <dsp:cNvSpPr/>
      </dsp:nvSpPr>
      <dsp:spPr>
        <a:xfrm>
          <a:off x="2183723" y="278166"/>
          <a:ext cx="1763093" cy="1529914"/>
        </a:xfrm>
        <a:prstGeom prst="roundRect">
          <a:avLst>
            <a:gd name="adj" fmla="val 10000"/>
          </a:avLst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1000" b="-1000"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2869E26-35C3-4008-BD69-BD8E75C3380D}">
      <dsp:nvSpPr>
        <dsp:cNvPr id="0" name=""/>
        <dsp:cNvSpPr/>
      </dsp:nvSpPr>
      <dsp:spPr>
        <a:xfrm rot="10800000">
          <a:off x="2183723" y="2086246"/>
          <a:ext cx="1763093" cy="2549857"/>
        </a:xfrm>
        <a:prstGeom prst="round2SameRect">
          <a:avLst>
            <a:gd name="adj1" fmla="val 10500"/>
            <a:gd name="adj2" fmla="val 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28016" tIns="128016" rIns="128016" bIns="128016" numCol="1" spcCol="1270" anchor="t" anchorCtr="0">
          <a:noAutofit/>
        </a:bodyPr>
        <a:lstStyle/>
        <a:p>
          <a:pPr marL="0" lvl="0" indent="0" algn="l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8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Reduction in weight and BMI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Improvement in insulin resistance (HOMA-IR)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significant changes in FSH and LH level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lowered testosterone levels</a:t>
          </a:r>
          <a:r>
            <a:rPr lang="en-US" sz="1400" kern="1200" dirty="0"/>
            <a:t> 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</dsp:txBody>
      <dsp:txXfrm rot="10800000">
        <a:off x="2237944" y="2086246"/>
        <a:ext cx="1654651" cy="2495636"/>
      </dsp:txXfrm>
    </dsp:sp>
    <dsp:sp modelId="{1FC4994D-E818-4BCF-9AB7-01F91FB0FD97}">
      <dsp:nvSpPr>
        <dsp:cNvPr id="0" name=""/>
        <dsp:cNvSpPr/>
      </dsp:nvSpPr>
      <dsp:spPr>
        <a:xfrm>
          <a:off x="4123126" y="278166"/>
          <a:ext cx="1763093" cy="1529914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9471" t="114" r="-10529" b="-9063"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E857C2D-4E34-4060-9469-B1C4B8797DFE}">
      <dsp:nvSpPr>
        <dsp:cNvPr id="0" name=""/>
        <dsp:cNvSpPr/>
      </dsp:nvSpPr>
      <dsp:spPr>
        <a:xfrm rot="10800000">
          <a:off x="4123126" y="2086246"/>
          <a:ext cx="1763093" cy="2549857"/>
        </a:xfrm>
        <a:prstGeom prst="round2SameRect">
          <a:avLst>
            <a:gd name="adj1" fmla="val 10500"/>
            <a:gd name="adj2" fmla="val 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0" lvl="0" indent="0" algn="l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6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Reduction in weight and BMI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changes in insulin resistance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Decrease FSH and LH levels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significant changes in testosterone levels 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</dsp:txBody>
      <dsp:txXfrm rot="10800000">
        <a:off x="4177347" y="2086246"/>
        <a:ext cx="1654651" cy="2495636"/>
      </dsp:txXfrm>
    </dsp:sp>
    <dsp:sp modelId="{41DE274A-0B87-4F82-8EBF-80EF4CC0C84C}">
      <dsp:nvSpPr>
        <dsp:cNvPr id="0" name=""/>
        <dsp:cNvSpPr/>
      </dsp:nvSpPr>
      <dsp:spPr>
        <a:xfrm>
          <a:off x="6062528" y="278166"/>
          <a:ext cx="1763093" cy="1529914"/>
        </a:xfrm>
        <a:prstGeom prst="roundRect">
          <a:avLst>
            <a:gd name="adj" fmla="val 10000"/>
          </a:avLst>
        </a:prstGeom>
        <a:blipFill dpi="0" rotWithShape="1"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10471" t="1334" r="-11529" b="-7234"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4F84DAC-A812-490E-B9F7-91C2480F621F}">
      <dsp:nvSpPr>
        <dsp:cNvPr id="0" name=""/>
        <dsp:cNvSpPr/>
      </dsp:nvSpPr>
      <dsp:spPr>
        <a:xfrm rot="10800000">
          <a:off x="6062528" y="2086246"/>
          <a:ext cx="1763093" cy="2549857"/>
        </a:xfrm>
        <a:prstGeom prst="round2SameRect">
          <a:avLst>
            <a:gd name="adj1" fmla="val 10500"/>
            <a:gd name="adj2" fmla="val 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5344" tIns="85344" rIns="85344" bIns="85344" numCol="1" spcCol="1270" anchor="t" anchorCtr="0">
          <a:noAutofit/>
        </a:bodyPr>
        <a:lstStyle/>
        <a:p>
          <a:pPr marL="0" lvl="0" indent="0" algn="l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600" kern="1200" dirty="0"/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Reduction in weight and BMI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Improvement in insulin resistance (HOMA-IR) 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No significant changes in FSH and LH</a:t>
          </a:r>
        </a:p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lowered testosterone levels </a:t>
          </a:r>
        </a:p>
        <a:p>
          <a:pPr marL="114300" lvl="1" indent="-114300" algn="l" defTabSz="6223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1400" kern="1200" dirty="0"/>
        </a:p>
      </dsp:txBody>
      <dsp:txXfrm rot="10800000">
        <a:off x="6116749" y="2086246"/>
        <a:ext cx="1654651" cy="249563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List2">
  <dgm:title val=""/>
  <dgm:desc val=""/>
  <dgm:catLst>
    <dgm:cat type="list" pri="11000"/>
    <dgm:cat type="picture" pri="24000"/>
    <dgm:cat type="pictureconvert" pri="24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alg type="composite"/>
    <dgm:shape xmlns:r="http://schemas.openxmlformats.org/officeDocument/2006/relationships" r:blip="">
      <dgm:adjLst/>
    </dgm:shape>
    <dgm:presOf/>
    <dgm:constrLst>
      <dgm:constr type="w" for="ch" forName="bkgdShp" refType="w"/>
      <dgm:constr type="h" for="ch" forName="bkgdShp" refType="h" fact="0.45"/>
      <dgm:constr type="t" for="ch" forName="bkgdShp"/>
      <dgm:constr type="w" for="ch" forName="linComp" refType="w" fact="0.94"/>
      <dgm:constr type="h" for="ch" forName="linComp" refType="h"/>
      <dgm:constr type="ctrX" for="ch" forName="linComp" refType="w" fact="0.5"/>
    </dgm:constrLst>
    <dgm:ruleLst/>
    <dgm:choose name="Name1">
      <dgm:if name="Name2" axis="ch" ptType="node" func="cnt" op="gte" val="1">
        <dgm:layoutNode name="bkgdShp" styleLbl="alignAccFollowNode1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/>
          <dgm:constrLst/>
          <dgm:ruleLst/>
        </dgm:layoutNode>
        <dgm:layoutNode name="linComp">
          <dgm:choose name="Name3">
            <dgm:if name="Name4" func="var" arg="dir" op="equ" val="norm">
              <dgm:alg type="lin"/>
            </dgm:if>
            <dgm:else name="Name5">
              <dgm:alg type="lin">
                <dgm:param type="linDir" val="fromR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>
            <dgm:constr type="w" for="ch" forName="compNode" refType="w"/>
            <dgm:constr type="h" for="ch" forName="compNode" refType="h"/>
            <dgm:constr type="w" for="ch" ptType="sibTrans" refType="w" refFor="ch" refForName="compNode" fact="0.1"/>
            <dgm:constr type="h" for="ch" ptType="sibTrans" op="equ"/>
            <dgm:constr type="h" for="ch" forName="compNode" op="equ"/>
            <dgm:constr type="primFontSz" for="des" forName="node" op="equ"/>
          </dgm:constrLst>
          <dgm:ruleLst/>
          <dgm:forEach name="nodesForEach" axis="ch" ptType="node">
            <dgm:layoutNode name="compNode">
              <dgm:alg type="composite"/>
              <dgm:shape xmlns:r="http://schemas.openxmlformats.org/officeDocument/2006/relationships" r:blip="">
                <dgm:adjLst/>
              </dgm:shape>
              <dgm:presOf/>
              <dgm:constrLst>
                <dgm:constr type="w" for="ch" forName="node" refType="w"/>
                <dgm:constr type="h" for="ch" forName="node" refType="h" fact="0.55"/>
                <dgm:constr type="b" for="ch" forName="node" refType="h"/>
                <dgm:constr type="w" for="ch" forName="invisiNode" refType="w" fact="0.75"/>
                <dgm:constr type="h" for="ch" forName="invisiNode" refType="h" fact="0.06"/>
                <dgm:constr type="t" for="ch" forName="invisiNode"/>
                <dgm:constr type="w" for="ch" forName="imagNode" refType="w"/>
                <dgm:constr type="h" for="ch" forName="imagNode" refType="h" fact="0.33"/>
                <dgm:constr type="ctrX" for="ch" forName="imagNode" refType="w" fact="0.5"/>
                <dgm:constr type="t" for="ch" forName="imagNode" refType="h" fact="0.06"/>
              </dgm:constrLst>
              <dgm:ruleLst/>
              <dgm:layoutNode name="node" styleLbl="node1">
                <dgm:varLst>
                  <dgm:bulletEnabled val="1"/>
                </dgm:varLst>
                <dgm:alg type="tx">
                  <dgm:param type="txAnchorVert" val="t"/>
                </dgm:alg>
                <dgm:shape xmlns:r="http://schemas.openxmlformats.org/officeDocument/2006/relationships" rot="180" type="round2SameRect" r:blip="">
                  <dgm:adjLst>
                    <dgm:adj idx="1" val="0.105"/>
                  </dgm:adjLst>
                </dgm:shape>
                <dgm:presOf axis="desOrSelf" ptType="node"/>
                <dgm:constrLst>
                  <dgm:constr type="primFontSz" val="65"/>
                </dgm:constrLst>
                <dgm:ruleLst>
                  <dgm:rule type="primFontSz" val="5" fact="NaN" max="NaN"/>
                </dgm:ruleLst>
              </dgm:layoutNode>
              <dgm:layoutNode name="invisiNode">
                <dgm:alg type="sp"/>
                <dgm:shape xmlns:r="http://schemas.openxmlformats.org/officeDocument/2006/relationships" type="roundRect" r:blip="" hideGeom="1">
                  <dgm:adjLst>
                    <dgm:adj idx="1" val="0.1"/>
                  </dgm:adjLst>
                </dgm:shape>
                <dgm:presOf/>
                <dgm:constrLst/>
                <dgm:ruleLst/>
              </dgm:layoutNode>
              <dgm:layoutNode name="imagNode" styleLbl="fgImgPlace1">
                <dgm:alg type="sp"/>
                <dgm:shape xmlns:r="http://schemas.openxmlformats.org/officeDocument/2006/relationships" type="roundRect" r:blip="" zOrderOff="-2" blipPhldr="1">
                  <dgm:adjLst>
                    <dgm:adj idx="1" val="0.1"/>
                  </dgm:adjLst>
                </dgm:shape>
                <dgm:presOf/>
                <dgm:constrLst/>
                <dgm:ruleLst/>
              </dgm:layoutNode>
            </dgm:layoutNode>
            <dgm:forEach name="sibTransForEach" axis="followSib" ptType="sibTrans" cnt="1">
              <dgm:layoutNode name="sibTrans">
                <dgm:alg type="sp"/>
                <dgm:shape xmlns:r="http://schemas.openxmlformats.org/officeDocument/2006/relationships" type="rect" r:blip="" hideGeom="1">
                  <dgm:adjLst/>
                </dgm:shape>
                <dgm:presOf axis="self"/>
                <dgm:constrLst/>
                <dgm:ruleLst/>
              </dgm:layoutNode>
            </dgm:forEach>
          </dgm:forEach>
        </dgm:layoutNode>
      </dgm:if>
      <dgm:else name="Name6"/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EC038-F073-2D62-F1CE-A58C1F3F94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B9ACAE-6430-3AF6-24F9-C3AC95B7D8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06EA65-97C0-7E3F-4738-DEF9225140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2C214-1E44-8487-9EA1-0CF00D1FC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F8656-6D04-622D-0061-78A9F64AC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712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1984BB-359D-049A-00EC-C6C2796A54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43AAEA-6810-8C55-6C15-620DC7442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375E97-0DFC-EEAF-024D-1CA699DFD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3143F1-A89B-A6B0-DE75-443D6DDFF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386A9D-5300-138F-66B1-69D056FF5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98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EB5B495-D8AB-7C3C-2620-70C712381C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C674C8-66B8-2704-C912-877C0F106D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89ED7E-7A9B-684C-8A6E-801F59B80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25256-8580-91EA-0469-1DAC31DD4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9428BC-DE28-C1FC-1DB8-60B2483E7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83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C17B2-F173-5F01-B3CF-65EA7D339D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5CC3F-97BE-4F99-DB25-9147004A9B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1A617-2D20-71D0-E31E-5E3155483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DC86F0-D8CE-B1B4-71A1-2EF90FC2E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1FA6D1-A3A0-6DBA-83CA-867C5EADC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357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C61C1-F64A-1C1B-F0C9-C064996BA1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68E20-7CFE-1083-BD95-66A2FA8B44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CED340-7E9C-1849-7171-E73605BB7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CE2E20-8860-895A-C054-FB4BA2A9E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5548C4-ABCF-6A57-66DD-E0D6790BD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649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AEA383-9A32-9010-18C1-BF3641CD4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43F371-4238-079D-EFA6-C681B21302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395C6E-FBBB-CB52-DD92-7D19AC6BA3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5A3429-5774-62EA-DEBA-75D7676EB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753E40-9F2B-4596-4FC4-28C628A53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6659B4-C382-94A3-5AB6-F043F4DA3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598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710E3-85E8-35A3-EE02-E7D02D1E7D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98C266-F852-83EE-C7AA-A8545A7D89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DC7FDD-F965-58F8-B105-65B1B9E225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866537-2AD8-7DA7-5E38-0B86DB9474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50B3BB8-3583-DCCC-D22D-E879A8EDF9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318E54-A4A7-4476-5B3D-784B4BA3C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77CB59D-05BB-6953-71CB-F787A419D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AF757B-9335-1936-1A97-150DDFD3E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945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E9A5D-C39B-FA53-66E7-39559C4D4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AE98FD-45F4-AC85-C38B-1FC08F587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A337FF-3DCC-23E5-A268-D32D40CDB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AE7408-8F43-9896-0DDD-7ED50B1AB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15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349FEC-A1F1-FF41-3A3D-A32CC036BA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39E847-E18C-BA96-94A1-DE2582AF3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E420D2-927B-6721-FD94-436F774D3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22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8B741-0623-6801-B234-442A9CE0C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D2536A-DCD3-DDAC-3E2D-4B1EF692D4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4680B3-4785-5EDC-4D1F-2E93EDA701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29CD56-D4BD-5651-452B-D2E92DDD5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6987A6-95A8-8560-1E86-6C7F09879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FE68A4-A87D-B23C-8A7D-CA9F2D73E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742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8C13F1-79C4-C033-2B52-5EFF8B428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9E0486-93B4-9834-E715-A61495A098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47E34D-4F67-321C-B6E6-A650BA6129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C02176-3251-8047-F459-6287D4FF5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B7DCF3-320D-2639-9E0B-BB0130BA6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965BBF-9BCE-B105-F117-FFB28299E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84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CCDE8E-E4E4-5B47-B3E8-B73BB7FB6C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77A8A1-546A-9FC3-94C4-16FFE97671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4AAD32-6B1C-CD8C-F92E-905E809312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DC6F9-C983-467A-B1E4-99F96C1C6174}" type="datetimeFigureOut">
              <a:rPr lang="en-US" smtClean="0"/>
              <a:t>10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74428A-5AAD-ACF0-2AD0-1E3C348452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8F490-4B51-A28C-6C67-597D8C8BE7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C52B9-5EAB-4104-B70F-43660A3C20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176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7" Type="http://schemas.openxmlformats.org/officeDocument/2006/relationships/image" Target="../media/image5.jp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4C555D34-0D6C-335A-B882-6A5E31FFD0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49290" y="102637"/>
            <a:ext cx="11887200" cy="6634065"/>
          </a:xfrm>
          <a:ln>
            <a:solidFill>
              <a:schemeClr val="bg1"/>
            </a:solidFill>
          </a:ln>
        </p:spPr>
        <p:txBody>
          <a:bodyPr/>
          <a:lstStyle/>
          <a:p>
            <a:endParaRPr lang="en-US" dirty="0"/>
          </a:p>
        </p:txBody>
      </p:sp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774D33B4-7D28-ADB4-B66E-B7CA61A5DB4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147295212"/>
              </p:ext>
            </p:extLst>
          </p:nvPr>
        </p:nvGraphicFramePr>
        <p:xfrm>
          <a:off x="1838129" y="1780938"/>
          <a:ext cx="8069943" cy="463610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C349CDD1-46C0-CA65-E003-E7297C81E0C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4858" y="121298"/>
            <a:ext cx="2962275" cy="154305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BD9E2A5-D0A7-4ED5-A1C8-266441FA9CA3}"/>
              </a:ext>
            </a:extLst>
          </p:cNvPr>
          <p:cNvSpPr txBox="1"/>
          <p:nvPr/>
        </p:nvSpPr>
        <p:spPr>
          <a:xfrm>
            <a:off x="7492482" y="923731"/>
            <a:ext cx="19407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n w="22225">
                  <a:solidFill>
                    <a:schemeClr val="accent2"/>
                  </a:solidFill>
                  <a:prstDash val="solid"/>
                </a:ln>
                <a:solidFill>
                  <a:schemeClr val="accent2">
                    <a:lumMod val="40000"/>
                    <a:lumOff val="60000"/>
                  </a:schemeClr>
                </a:solidFill>
              </a:rPr>
              <a:t>PCO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9EFF94-CD1A-E0D2-894A-CC93CE6F8D00}"/>
              </a:ext>
            </a:extLst>
          </p:cNvPr>
          <p:cNvSpPr txBox="1"/>
          <p:nvPr/>
        </p:nvSpPr>
        <p:spPr>
          <a:xfrm>
            <a:off x="74645" y="6434867"/>
            <a:ext cx="120364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ictorial representation of the effect of cinnamon, ginger, metformin on PCOS</a:t>
            </a:r>
          </a:p>
          <a:p>
            <a:r>
              <a:rPr lang="en-US" sz="1200" dirty="0"/>
              <a:t>Abbreviations: PCOS:  Polycystic ovary syndrome, BMI: body mass index, FSH: follicle-stimulating hormone, LH: luteinizing hormone </a:t>
            </a:r>
          </a:p>
        </p:txBody>
      </p:sp>
    </p:spTree>
    <p:extLst>
      <p:ext uri="{BB962C8B-B14F-4D97-AF65-F5344CB8AC3E}">
        <p14:creationId xmlns:p14="http://schemas.microsoft.com/office/powerpoint/2010/main" val="3212117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26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mon</dc:creator>
  <cp:lastModifiedBy>Damon</cp:lastModifiedBy>
  <cp:revision>8</cp:revision>
  <dcterms:created xsi:type="dcterms:W3CDTF">2022-10-29T09:37:15Z</dcterms:created>
  <dcterms:modified xsi:type="dcterms:W3CDTF">2022-10-29T10:15:34Z</dcterms:modified>
</cp:coreProperties>
</file>